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75" d="100"/>
          <a:sy n="75" d="100"/>
        </p:scale>
        <p:origin x="2208" y="43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éctor Cañeque Rufo" userId="6da3b7e2-2289-4c25-b14d-207ec07af19d" providerId="ADAL" clId="{20D992C6-2F6F-4D11-ACC2-BE7C9020AFDF}"/>
    <pc:docChg chg="custSel modSld">
      <pc:chgData name="Héctor Cañeque Rufo" userId="6da3b7e2-2289-4c25-b14d-207ec07af19d" providerId="ADAL" clId="{20D992C6-2F6F-4D11-ACC2-BE7C9020AFDF}" dt="2024-01-28T13:21:20.366" v="29" actId="313"/>
      <pc:docMkLst>
        <pc:docMk/>
      </pc:docMkLst>
      <pc:sldChg chg="modSp mod">
        <pc:chgData name="Héctor Cañeque Rufo" userId="6da3b7e2-2289-4c25-b14d-207ec07af19d" providerId="ADAL" clId="{20D992C6-2F6F-4D11-ACC2-BE7C9020AFDF}" dt="2024-01-28T13:21:20.366" v="29" actId="313"/>
        <pc:sldMkLst>
          <pc:docMk/>
          <pc:sldMk cId="4077600714" sldId="260"/>
        </pc:sldMkLst>
        <pc:spChg chg="mod">
          <ac:chgData name="Héctor Cañeque Rufo" userId="6da3b7e2-2289-4c25-b14d-207ec07af19d" providerId="ADAL" clId="{20D992C6-2F6F-4D11-ACC2-BE7C9020AFDF}" dt="2024-01-28T13:21:20.366" v="29" actId="313"/>
          <ac:spMkLst>
            <pc:docMk/>
            <pc:sldMk cId="4077600714" sldId="260"/>
            <ac:spMk id="6" creationId="{CCCB4646-A728-A888-3305-97837D3E0B25}"/>
          </ac:spMkLst>
        </pc:spChg>
      </pc:sldChg>
    </pc:docChg>
  </pc:docChgLst>
  <pc:docChgLst>
    <pc:chgData name="Héctor Cañeque Rufo" userId="6da3b7e2-2289-4c25-b14d-207ec07af19d" providerId="ADAL" clId="{883D0FED-CFFD-47C2-95A4-7902BC77C820}"/>
    <pc:docChg chg="delSld">
      <pc:chgData name="Héctor Cañeque Rufo" userId="6da3b7e2-2289-4c25-b14d-207ec07af19d" providerId="ADAL" clId="{883D0FED-CFFD-47C2-95A4-7902BC77C820}" dt="2024-01-10T15:13:43.930" v="0" actId="2696"/>
      <pc:docMkLst>
        <pc:docMk/>
      </pc:docMkLst>
      <pc:sldChg chg="del">
        <pc:chgData name="Héctor Cañeque Rufo" userId="6da3b7e2-2289-4c25-b14d-207ec07af19d" providerId="ADAL" clId="{883D0FED-CFFD-47C2-95A4-7902BC77C820}" dt="2024-01-10T15:13:43.930" v="0" actId="2696"/>
        <pc:sldMkLst>
          <pc:docMk/>
          <pc:sldMk cId="3649846329" sldId="257"/>
        </pc:sldMkLst>
      </pc:sldChg>
      <pc:sldChg chg="del">
        <pc:chgData name="Héctor Cañeque Rufo" userId="6da3b7e2-2289-4c25-b14d-207ec07af19d" providerId="ADAL" clId="{883D0FED-CFFD-47C2-95A4-7902BC77C820}" dt="2024-01-10T15:13:43.930" v="0" actId="2696"/>
        <pc:sldMkLst>
          <pc:docMk/>
          <pc:sldMk cId="2991595023" sldId="259"/>
        </pc:sldMkLst>
      </pc:sldChg>
      <pc:sldChg chg="del">
        <pc:chgData name="Héctor Cañeque Rufo" userId="6da3b7e2-2289-4c25-b14d-207ec07af19d" providerId="ADAL" clId="{883D0FED-CFFD-47C2-95A4-7902BC77C820}" dt="2024-01-10T15:13:43.930" v="0" actId="2696"/>
        <pc:sldMkLst>
          <pc:docMk/>
          <pc:sldMk cId="2134677172" sldId="261"/>
        </pc:sldMkLst>
      </pc:sldChg>
    </pc:docChg>
  </pc:docChgLst>
  <pc:docChgLst>
    <pc:chgData name="Héctor Cañeque Rufo" userId="6da3b7e2-2289-4c25-b14d-207ec07af19d" providerId="ADAL" clId="{495F2243-7A7C-4B18-A6AD-E5E11BECB84D}"/>
    <pc:docChg chg="undo custSel addSld modSld sldOrd">
      <pc:chgData name="Héctor Cañeque Rufo" userId="6da3b7e2-2289-4c25-b14d-207ec07af19d" providerId="ADAL" clId="{495F2243-7A7C-4B18-A6AD-E5E11BECB84D}" dt="2024-01-10T15:09:31.091" v="1850"/>
      <pc:docMkLst>
        <pc:docMk/>
      </pc:docMkLst>
      <pc:sldChg chg="addSp delSp modSp mod ord">
        <pc:chgData name="Héctor Cañeque Rufo" userId="6da3b7e2-2289-4c25-b14d-207ec07af19d" providerId="ADAL" clId="{495F2243-7A7C-4B18-A6AD-E5E11BECB84D}" dt="2024-01-10T15:09:31.091" v="1850"/>
        <pc:sldMkLst>
          <pc:docMk/>
          <pc:sldMk cId="3649846329" sldId="257"/>
        </pc:sldMkLst>
        <pc:spChg chg="mod topLvl">
          <ac:chgData name="Héctor Cañeque Rufo" userId="6da3b7e2-2289-4c25-b14d-207ec07af19d" providerId="ADAL" clId="{495F2243-7A7C-4B18-A6AD-E5E11BECB84D}" dt="2024-01-10T14:50:59.499" v="840" actId="12789"/>
          <ac:spMkLst>
            <pc:docMk/>
            <pc:sldMk cId="3649846329" sldId="257"/>
            <ac:spMk id="2" creationId="{2803F996-BD38-4464-FA93-D50F1B72AF57}"/>
          </ac:spMkLst>
        </pc:spChg>
        <pc:spChg chg="mod topLvl">
          <ac:chgData name="Héctor Cañeque Rufo" userId="6da3b7e2-2289-4c25-b14d-207ec07af19d" providerId="ADAL" clId="{495F2243-7A7C-4B18-A6AD-E5E11BECB84D}" dt="2024-01-10T14:50:59.499" v="840" actId="12789"/>
          <ac:spMkLst>
            <pc:docMk/>
            <pc:sldMk cId="3649846329" sldId="257"/>
            <ac:spMk id="3" creationId="{6796E5AE-8DD8-E698-D0E9-4745AE9B025E}"/>
          </ac:spMkLst>
        </pc:spChg>
        <pc:spChg chg="mod topLvl">
          <ac:chgData name="Héctor Cañeque Rufo" userId="6da3b7e2-2289-4c25-b14d-207ec07af19d" providerId="ADAL" clId="{495F2243-7A7C-4B18-A6AD-E5E11BECB84D}" dt="2024-01-10T14:58:10.699" v="1301" actId="1035"/>
          <ac:spMkLst>
            <pc:docMk/>
            <pc:sldMk cId="3649846329" sldId="257"/>
            <ac:spMk id="4" creationId="{93C1E1F6-630F-01A1-17F3-E572FF984990}"/>
          </ac:spMkLst>
        </pc:spChg>
        <pc:spChg chg="del mod topLvl">
          <ac:chgData name="Héctor Cañeque Rufo" userId="6da3b7e2-2289-4c25-b14d-207ec07af19d" providerId="ADAL" clId="{495F2243-7A7C-4B18-A6AD-E5E11BECB84D}" dt="2024-01-10T14:57:41.420" v="1034" actId="478"/>
          <ac:spMkLst>
            <pc:docMk/>
            <pc:sldMk cId="3649846329" sldId="257"/>
            <ac:spMk id="5" creationId="{35E75241-8090-BEB8-18D2-0F7DE932FC9D}"/>
          </ac:spMkLst>
        </pc:spChg>
        <pc:spChg chg="mod topLvl">
          <ac:chgData name="Héctor Cañeque Rufo" userId="6da3b7e2-2289-4c25-b14d-207ec07af19d" providerId="ADAL" clId="{495F2243-7A7C-4B18-A6AD-E5E11BECB84D}" dt="2024-01-10T14:36:29.534" v="190" actId="1035"/>
          <ac:spMkLst>
            <pc:docMk/>
            <pc:sldMk cId="3649846329" sldId="257"/>
            <ac:spMk id="22" creationId="{6A807A99-5770-26EF-83F9-A6A8D108BAE3}"/>
          </ac:spMkLst>
        </pc:spChg>
        <pc:spChg chg="mod ord topLvl">
          <ac:chgData name="Héctor Cañeque Rufo" userId="6da3b7e2-2289-4c25-b14d-207ec07af19d" providerId="ADAL" clId="{495F2243-7A7C-4B18-A6AD-E5E11BECB84D}" dt="2024-01-10T14:36:46.407" v="199" actId="1037"/>
          <ac:spMkLst>
            <pc:docMk/>
            <pc:sldMk cId="3649846329" sldId="257"/>
            <ac:spMk id="127" creationId="{0215AD33-6AF5-C805-CD40-68BF691BFFA0}"/>
          </ac:spMkLst>
        </pc:spChg>
        <pc:grpChg chg="del mod topLvl">
          <ac:chgData name="Héctor Cañeque Rufo" userId="6da3b7e2-2289-4c25-b14d-207ec07af19d" providerId="ADAL" clId="{495F2243-7A7C-4B18-A6AD-E5E11BECB84D}" dt="2024-01-10T14:36:05.468" v="177" actId="165"/>
          <ac:grpSpMkLst>
            <pc:docMk/>
            <pc:sldMk cId="3649846329" sldId="257"/>
            <ac:grpSpMk id="8" creationId="{14A77C6F-1CB5-006C-BAD9-D009FBEAB367}"/>
          </ac:grpSpMkLst>
        </pc:grpChg>
        <pc:grpChg chg="del mod">
          <ac:chgData name="Héctor Cañeque Rufo" userId="6da3b7e2-2289-4c25-b14d-207ec07af19d" providerId="ADAL" clId="{495F2243-7A7C-4B18-A6AD-E5E11BECB84D}" dt="2024-01-10T14:35:59.313" v="176" actId="165"/>
          <ac:grpSpMkLst>
            <pc:docMk/>
            <pc:sldMk cId="3649846329" sldId="257"/>
            <ac:grpSpMk id="128" creationId="{30C19935-BF34-7BBB-2A21-239F2F8664AE}"/>
          </ac:grpSpMkLst>
        </pc:grpChg>
        <pc:picChg chg="del">
          <ac:chgData name="Héctor Cañeque Rufo" userId="6da3b7e2-2289-4c25-b14d-207ec07af19d" providerId="ADAL" clId="{495F2243-7A7C-4B18-A6AD-E5E11BECB84D}" dt="2024-01-10T14:34:45.766" v="97" actId="478"/>
          <ac:picMkLst>
            <pc:docMk/>
            <pc:sldMk cId="3649846329" sldId="257"/>
            <ac:picMk id="6" creationId="{C47E6BA4-4479-B515-6C61-9218E35EA25F}"/>
          </ac:picMkLst>
        </pc:picChg>
        <pc:picChg chg="add mod ord">
          <ac:chgData name="Héctor Cañeque Rufo" userId="6da3b7e2-2289-4c25-b14d-207ec07af19d" providerId="ADAL" clId="{495F2243-7A7C-4B18-A6AD-E5E11BECB84D}" dt="2024-01-10T14:36:46.407" v="199" actId="1037"/>
          <ac:picMkLst>
            <pc:docMk/>
            <pc:sldMk cId="3649846329" sldId="257"/>
            <ac:picMk id="7" creationId="{3701548B-1FAF-0049-1EF4-8CD2F44AFE36}"/>
          </ac:picMkLst>
        </pc:picChg>
        <pc:picChg chg="add mod ord">
          <ac:chgData name="Héctor Cañeque Rufo" userId="6da3b7e2-2289-4c25-b14d-207ec07af19d" providerId="ADAL" clId="{495F2243-7A7C-4B18-A6AD-E5E11BECB84D}" dt="2024-01-10T14:36:18.805" v="179" actId="167"/>
          <ac:picMkLst>
            <pc:docMk/>
            <pc:sldMk cId="3649846329" sldId="257"/>
            <ac:picMk id="10" creationId="{2A8E2CC7-5BA7-5D29-53A4-5730BFE9F980}"/>
          </ac:picMkLst>
        </pc:picChg>
        <pc:picChg chg="add del">
          <ac:chgData name="Héctor Cañeque Rufo" userId="6da3b7e2-2289-4c25-b14d-207ec07af19d" providerId="ADAL" clId="{495F2243-7A7C-4B18-A6AD-E5E11BECB84D}" dt="2024-01-10T14:39:26.317" v="201" actId="478"/>
          <ac:picMkLst>
            <pc:docMk/>
            <pc:sldMk cId="3649846329" sldId="257"/>
            <ac:picMk id="11" creationId="{CDE50B0F-BAB0-6523-5AB5-449CFCEABC62}"/>
          </ac:picMkLst>
        </pc:picChg>
        <pc:picChg chg="del mod topLvl">
          <ac:chgData name="Héctor Cañeque Rufo" userId="6da3b7e2-2289-4c25-b14d-207ec07af19d" providerId="ADAL" clId="{495F2243-7A7C-4B18-A6AD-E5E11BECB84D}" dt="2024-01-10T14:43:58.980" v="254" actId="478"/>
          <ac:picMkLst>
            <pc:docMk/>
            <pc:sldMk cId="3649846329" sldId="257"/>
            <ac:picMk id="12" creationId="{9C80E917-8625-BD51-DB49-917151A4F2D2}"/>
          </ac:picMkLst>
        </pc:picChg>
        <pc:picChg chg="del mod topLvl">
          <ac:chgData name="Héctor Cañeque Rufo" userId="6da3b7e2-2289-4c25-b14d-207ec07af19d" providerId="ADAL" clId="{495F2243-7A7C-4B18-A6AD-E5E11BECB84D}" dt="2024-01-10T14:44:01.168" v="255" actId="478"/>
          <ac:picMkLst>
            <pc:docMk/>
            <pc:sldMk cId="3649846329" sldId="257"/>
            <ac:picMk id="13" creationId="{7A3A51E2-91FA-7E94-C135-E09B6717C731}"/>
          </ac:picMkLst>
        </pc:picChg>
        <pc:picChg chg="add del mod ord">
          <ac:chgData name="Héctor Cañeque Rufo" userId="6da3b7e2-2289-4c25-b14d-207ec07af19d" providerId="ADAL" clId="{495F2243-7A7C-4B18-A6AD-E5E11BECB84D}" dt="2024-01-10T14:47:57.598" v="569" actId="478"/>
          <ac:picMkLst>
            <pc:docMk/>
            <pc:sldMk cId="3649846329" sldId="257"/>
            <ac:picMk id="14" creationId="{A25B8E3A-54CF-C0C2-2716-645FDA5BA4B9}"/>
          </ac:picMkLst>
        </pc:picChg>
        <pc:picChg chg="add mod ord">
          <ac:chgData name="Héctor Cañeque Rufo" userId="6da3b7e2-2289-4c25-b14d-207ec07af19d" providerId="ADAL" clId="{495F2243-7A7C-4B18-A6AD-E5E11BECB84D}" dt="2024-01-10T14:48:45.674" v="757" actId="167"/>
          <ac:picMkLst>
            <pc:docMk/>
            <pc:sldMk cId="3649846329" sldId="257"/>
            <ac:picMk id="15" creationId="{D43D65F3-E438-DA6E-27F5-450D605E6605}"/>
          </ac:picMkLst>
        </pc:picChg>
        <pc:picChg chg="add mod ord">
          <ac:chgData name="Héctor Cañeque Rufo" userId="6da3b7e2-2289-4c25-b14d-207ec07af19d" providerId="ADAL" clId="{495F2243-7A7C-4B18-A6AD-E5E11BECB84D}" dt="2024-01-10T14:48:45.674" v="757" actId="167"/>
          <ac:picMkLst>
            <pc:docMk/>
            <pc:sldMk cId="3649846329" sldId="257"/>
            <ac:picMk id="16" creationId="{F34DD8E2-1306-4381-1EE7-407C5CA8AF92}"/>
          </ac:picMkLst>
        </pc:picChg>
        <pc:picChg chg="add del mod ord">
          <ac:chgData name="Héctor Cañeque Rufo" userId="6da3b7e2-2289-4c25-b14d-207ec07af19d" providerId="ADAL" clId="{495F2243-7A7C-4B18-A6AD-E5E11BECB84D}" dt="2024-01-10T15:03:46.292" v="1354" actId="478"/>
          <ac:picMkLst>
            <pc:docMk/>
            <pc:sldMk cId="3649846329" sldId="257"/>
            <ac:picMk id="17" creationId="{F78F7E76-B65E-17FF-2C00-BCBE6AE44082}"/>
          </ac:picMkLst>
        </pc:picChg>
        <pc:picChg chg="del mod topLvl">
          <ac:chgData name="Héctor Cañeque Rufo" userId="6da3b7e2-2289-4c25-b14d-207ec07af19d" providerId="ADAL" clId="{495F2243-7A7C-4B18-A6AD-E5E11BECB84D}" dt="2024-01-10T14:43:51.019" v="253" actId="478"/>
          <ac:picMkLst>
            <pc:docMk/>
            <pc:sldMk cId="3649846329" sldId="257"/>
            <ac:picMk id="18" creationId="{DA55C7F4-6D6B-A553-D147-77A365D4BCF8}"/>
          </ac:picMkLst>
        </pc:picChg>
        <pc:picChg chg="del mod topLvl">
          <ac:chgData name="Héctor Cañeque Rufo" userId="6da3b7e2-2289-4c25-b14d-207ec07af19d" providerId="ADAL" clId="{495F2243-7A7C-4B18-A6AD-E5E11BECB84D}" dt="2024-01-10T14:44:03.476" v="256" actId="478"/>
          <ac:picMkLst>
            <pc:docMk/>
            <pc:sldMk cId="3649846329" sldId="257"/>
            <ac:picMk id="19" creationId="{9724040B-0196-9AD6-E635-0094BB96A211}"/>
          </ac:picMkLst>
        </pc:picChg>
        <pc:picChg chg="add mod ord">
          <ac:chgData name="Héctor Cañeque Rufo" userId="6da3b7e2-2289-4c25-b14d-207ec07af19d" providerId="ADAL" clId="{495F2243-7A7C-4B18-A6AD-E5E11BECB84D}" dt="2024-01-10T15:03:43.614" v="1353" actId="167"/>
          <ac:picMkLst>
            <pc:docMk/>
            <pc:sldMk cId="3649846329" sldId="257"/>
            <ac:picMk id="20" creationId="{FB61C11C-49FF-71D1-B281-A4CAB7515C0F}"/>
          </ac:picMkLst>
        </pc:picChg>
        <pc:picChg chg="del">
          <ac:chgData name="Héctor Cañeque Rufo" userId="6da3b7e2-2289-4c25-b14d-207ec07af19d" providerId="ADAL" clId="{495F2243-7A7C-4B18-A6AD-E5E11BECB84D}" dt="2024-01-10T14:33:27.265" v="50" actId="478"/>
          <ac:picMkLst>
            <pc:docMk/>
            <pc:sldMk cId="3649846329" sldId="257"/>
            <ac:picMk id="126" creationId="{B96D4EE1-7E6A-97AD-B784-B09181F7E8F7}"/>
          </ac:picMkLst>
        </pc:picChg>
      </pc:sldChg>
      <pc:sldChg chg="addSp delSp modSp add mod ord">
        <pc:chgData name="Héctor Cañeque Rufo" userId="6da3b7e2-2289-4c25-b14d-207ec07af19d" providerId="ADAL" clId="{495F2243-7A7C-4B18-A6AD-E5E11BECB84D}" dt="2024-01-10T15:09:20.672" v="1846" actId="6549"/>
        <pc:sldMkLst>
          <pc:docMk/>
          <pc:sldMk cId="4077600714" sldId="260"/>
        </pc:sldMkLst>
        <pc:spChg chg="del">
          <ac:chgData name="Héctor Cañeque Rufo" userId="6da3b7e2-2289-4c25-b14d-207ec07af19d" providerId="ADAL" clId="{495F2243-7A7C-4B18-A6AD-E5E11BECB84D}" dt="2024-01-10T15:04:03.923" v="1361" actId="478"/>
          <ac:spMkLst>
            <pc:docMk/>
            <pc:sldMk cId="4077600714" sldId="260"/>
            <ac:spMk id="2" creationId="{2803F996-BD38-4464-FA93-D50F1B72AF57}"/>
          </ac:spMkLst>
        </pc:spChg>
        <pc:spChg chg="del">
          <ac:chgData name="Héctor Cañeque Rufo" userId="6da3b7e2-2289-4c25-b14d-207ec07af19d" providerId="ADAL" clId="{495F2243-7A7C-4B18-A6AD-E5E11BECB84D}" dt="2024-01-10T15:04:01.900" v="1360" actId="478"/>
          <ac:spMkLst>
            <pc:docMk/>
            <pc:sldMk cId="4077600714" sldId="260"/>
            <ac:spMk id="3" creationId="{6796E5AE-8DD8-E698-D0E9-4745AE9B025E}"/>
          </ac:spMkLst>
        </pc:spChg>
        <pc:spChg chg="del">
          <ac:chgData name="Héctor Cañeque Rufo" userId="6da3b7e2-2289-4c25-b14d-207ec07af19d" providerId="ADAL" clId="{495F2243-7A7C-4B18-A6AD-E5E11BECB84D}" dt="2024-01-10T15:04:10.513" v="1365" actId="478"/>
          <ac:spMkLst>
            <pc:docMk/>
            <pc:sldMk cId="4077600714" sldId="260"/>
            <ac:spMk id="4" creationId="{93C1E1F6-630F-01A1-17F3-E572FF984990}"/>
          </ac:spMkLst>
        </pc:spChg>
        <pc:spChg chg="add mod">
          <ac:chgData name="Héctor Cañeque Rufo" userId="6da3b7e2-2289-4c25-b14d-207ec07af19d" providerId="ADAL" clId="{495F2243-7A7C-4B18-A6AD-E5E11BECB84D}" dt="2024-01-10T15:09:20.672" v="1846" actId="6549"/>
          <ac:spMkLst>
            <pc:docMk/>
            <pc:sldMk cId="4077600714" sldId="260"/>
            <ac:spMk id="6" creationId="{CCCB4646-A728-A888-3305-97837D3E0B25}"/>
          </ac:spMkLst>
        </pc:spChg>
        <pc:spChg chg="del">
          <ac:chgData name="Héctor Cañeque Rufo" userId="6da3b7e2-2289-4c25-b14d-207ec07af19d" providerId="ADAL" clId="{495F2243-7A7C-4B18-A6AD-E5E11BECB84D}" dt="2024-01-10T15:04:06.882" v="1363" actId="478"/>
          <ac:spMkLst>
            <pc:docMk/>
            <pc:sldMk cId="4077600714" sldId="260"/>
            <ac:spMk id="22" creationId="{6A807A99-5770-26EF-83F9-A6A8D108BAE3}"/>
          </ac:spMkLst>
        </pc:spChg>
        <pc:spChg chg="del">
          <ac:chgData name="Héctor Cañeque Rufo" userId="6da3b7e2-2289-4c25-b14d-207ec07af19d" providerId="ADAL" clId="{495F2243-7A7C-4B18-A6AD-E5E11BECB84D}" dt="2024-01-10T15:04:17.237" v="1367" actId="478"/>
          <ac:spMkLst>
            <pc:docMk/>
            <pc:sldMk cId="4077600714" sldId="260"/>
            <ac:spMk id="127" creationId="{0215AD33-6AF5-C805-CD40-68BF691BFFA0}"/>
          </ac:spMkLst>
        </pc:spChg>
        <pc:picChg chg="add del">
          <ac:chgData name="Héctor Cañeque Rufo" userId="6da3b7e2-2289-4c25-b14d-207ec07af19d" providerId="ADAL" clId="{495F2243-7A7C-4B18-A6AD-E5E11BECB84D}" dt="2024-01-10T15:08:42.344" v="1731" actId="478"/>
          <ac:picMkLst>
            <pc:docMk/>
            <pc:sldMk cId="4077600714" sldId="260"/>
            <ac:picMk id="5" creationId="{2EF3E2C8-A894-95B2-353C-EC74557864BD}"/>
          </ac:picMkLst>
        </pc:picChg>
        <pc:picChg chg="mod">
          <ac:chgData name="Héctor Cañeque Rufo" userId="6da3b7e2-2289-4c25-b14d-207ec07af19d" providerId="ADAL" clId="{495F2243-7A7C-4B18-A6AD-E5E11BECB84D}" dt="2024-01-10T15:04:25.477" v="1369" actId="1076"/>
          <ac:picMkLst>
            <pc:docMk/>
            <pc:sldMk cId="4077600714" sldId="260"/>
            <ac:picMk id="7" creationId="{3701548B-1FAF-0049-1EF4-8CD2F44AFE36}"/>
          </ac:picMkLst>
        </pc:picChg>
        <pc:picChg chg="del">
          <ac:chgData name="Héctor Cañeque Rufo" userId="6da3b7e2-2289-4c25-b14d-207ec07af19d" providerId="ADAL" clId="{495F2243-7A7C-4B18-A6AD-E5E11BECB84D}" dt="2024-01-10T15:04:04.754" v="1362" actId="478"/>
          <ac:picMkLst>
            <pc:docMk/>
            <pc:sldMk cId="4077600714" sldId="260"/>
            <ac:picMk id="10" creationId="{2A8E2CC7-5BA7-5D29-53A4-5730BFE9F980}"/>
          </ac:picMkLst>
        </pc:picChg>
        <pc:picChg chg="del">
          <ac:chgData name="Héctor Cañeque Rufo" userId="6da3b7e2-2289-4c25-b14d-207ec07af19d" providerId="ADAL" clId="{495F2243-7A7C-4B18-A6AD-E5E11BECB84D}" dt="2024-01-10T15:03:59.456" v="1358" actId="478"/>
          <ac:picMkLst>
            <pc:docMk/>
            <pc:sldMk cId="4077600714" sldId="260"/>
            <ac:picMk id="15" creationId="{D43D65F3-E438-DA6E-27F5-450D605E6605}"/>
          </ac:picMkLst>
        </pc:picChg>
        <pc:picChg chg="del">
          <ac:chgData name="Héctor Cañeque Rufo" userId="6da3b7e2-2289-4c25-b14d-207ec07af19d" providerId="ADAL" clId="{495F2243-7A7C-4B18-A6AD-E5E11BECB84D}" dt="2024-01-10T15:03:59.995" v="1359" actId="478"/>
          <ac:picMkLst>
            <pc:docMk/>
            <pc:sldMk cId="4077600714" sldId="260"/>
            <ac:picMk id="16" creationId="{F34DD8E2-1306-4381-1EE7-407C5CA8AF92}"/>
          </ac:picMkLst>
        </pc:picChg>
        <pc:picChg chg="del">
          <ac:chgData name="Héctor Cañeque Rufo" userId="6da3b7e2-2289-4c25-b14d-207ec07af19d" providerId="ADAL" clId="{495F2243-7A7C-4B18-A6AD-E5E11BECB84D}" dt="2024-01-10T15:04:07.810" v="1364" actId="478"/>
          <ac:picMkLst>
            <pc:docMk/>
            <pc:sldMk cId="4077600714" sldId="260"/>
            <ac:picMk id="20" creationId="{FB61C11C-49FF-71D1-B281-A4CAB7515C0F}"/>
          </ac:picMkLst>
        </pc:picChg>
      </pc:sldChg>
      <pc:sldChg chg="addSp delSp modSp add mod">
        <pc:chgData name="Héctor Cañeque Rufo" userId="6da3b7e2-2289-4c25-b14d-207ec07af19d" providerId="ADAL" clId="{495F2243-7A7C-4B18-A6AD-E5E11BECB84D}" dt="2024-01-10T15:07:29.741" v="1729" actId="1038"/>
        <pc:sldMkLst>
          <pc:docMk/>
          <pc:sldMk cId="2134677172" sldId="261"/>
        </pc:sldMkLst>
        <pc:spChg chg="mod">
          <ac:chgData name="Héctor Cañeque Rufo" userId="6da3b7e2-2289-4c25-b14d-207ec07af19d" providerId="ADAL" clId="{495F2243-7A7C-4B18-A6AD-E5E11BECB84D}" dt="2024-01-10T15:06:32.760" v="1695" actId="1036"/>
          <ac:spMkLst>
            <pc:docMk/>
            <pc:sldMk cId="2134677172" sldId="261"/>
            <ac:spMk id="2" creationId="{2803F996-BD38-4464-FA93-D50F1B72AF57}"/>
          </ac:spMkLst>
        </pc:spChg>
        <pc:spChg chg="mod">
          <ac:chgData name="Héctor Cañeque Rufo" userId="6da3b7e2-2289-4c25-b14d-207ec07af19d" providerId="ADAL" clId="{495F2243-7A7C-4B18-A6AD-E5E11BECB84D}" dt="2024-01-10T15:07:29.741" v="1729" actId="1038"/>
          <ac:spMkLst>
            <pc:docMk/>
            <pc:sldMk cId="2134677172" sldId="261"/>
            <ac:spMk id="3" creationId="{6796E5AE-8DD8-E698-D0E9-4745AE9B025E}"/>
          </ac:spMkLst>
        </pc:spChg>
        <pc:spChg chg="del mod">
          <ac:chgData name="Héctor Cañeque Rufo" userId="6da3b7e2-2289-4c25-b14d-207ec07af19d" providerId="ADAL" clId="{495F2243-7A7C-4B18-A6AD-E5E11BECB84D}" dt="2024-01-10T15:06:03.085" v="1650" actId="478"/>
          <ac:spMkLst>
            <pc:docMk/>
            <pc:sldMk cId="2134677172" sldId="261"/>
            <ac:spMk id="4" creationId="{93C1E1F6-630F-01A1-17F3-E572FF984990}"/>
          </ac:spMkLst>
        </pc:spChg>
        <pc:spChg chg="add mod">
          <ac:chgData name="Héctor Cañeque Rufo" userId="6da3b7e2-2289-4c25-b14d-207ec07af19d" providerId="ADAL" clId="{495F2243-7A7C-4B18-A6AD-E5E11BECB84D}" dt="2024-01-10T15:07:29.741" v="1729" actId="1038"/>
          <ac:spMkLst>
            <pc:docMk/>
            <pc:sldMk cId="2134677172" sldId="261"/>
            <ac:spMk id="6" creationId="{792ED979-CC90-FA24-12E6-9E2834AE033A}"/>
          </ac:spMkLst>
        </pc:spChg>
        <pc:spChg chg="mod">
          <ac:chgData name="Héctor Cañeque Rufo" userId="6da3b7e2-2289-4c25-b14d-207ec07af19d" providerId="ADAL" clId="{495F2243-7A7C-4B18-A6AD-E5E11BECB84D}" dt="2024-01-10T15:07:00.294" v="1709" actId="1035"/>
          <ac:spMkLst>
            <pc:docMk/>
            <pc:sldMk cId="2134677172" sldId="261"/>
            <ac:spMk id="22" creationId="{6A807A99-5770-26EF-83F9-A6A8D108BAE3}"/>
          </ac:spMkLst>
        </pc:spChg>
        <pc:spChg chg="del">
          <ac:chgData name="Héctor Cañeque Rufo" userId="6da3b7e2-2289-4c25-b14d-207ec07af19d" providerId="ADAL" clId="{495F2243-7A7C-4B18-A6AD-E5E11BECB84D}" dt="2024-01-10T15:05:07.697" v="1381" actId="478"/>
          <ac:spMkLst>
            <pc:docMk/>
            <pc:sldMk cId="2134677172" sldId="261"/>
            <ac:spMk id="127" creationId="{0215AD33-6AF5-C805-CD40-68BF691BFFA0}"/>
          </ac:spMkLst>
        </pc:spChg>
        <pc:picChg chg="add mod">
          <ac:chgData name="Héctor Cañeque Rufo" userId="6da3b7e2-2289-4c25-b14d-207ec07af19d" providerId="ADAL" clId="{495F2243-7A7C-4B18-A6AD-E5E11BECB84D}" dt="2024-01-10T15:07:29.741" v="1729" actId="1038"/>
          <ac:picMkLst>
            <pc:docMk/>
            <pc:sldMk cId="2134677172" sldId="261"/>
            <ac:picMk id="5" creationId="{FDE526F4-48F8-79E2-58C5-41B3B991D23F}"/>
          </ac:picMkLst>
        </pc:picChg>
        <pc:picChg chg="del">
          <ac:chgData name="Héctor Cañeque Rufo" userId="6da3b7e2-2289-4c25-b14d-207ec07af19d" providerId="ADAL" clId="{495F2243-7A7C-4B18-A6AD-E5E11BECB84D}" dt="2024-01-10T15:04:40.529" v="1371" actId="478"/>
          <ac:picMkLst>
            <pc:docMk/>
            <pc:sldMk cId="2134677172" sldId="261"/>
            <ac:picMk id="7" creationId="{3701548B-1FAF-0049-1EF4-8CD2F44AFE36}"/>
          </ac:picMkLst>
        </pc:picChg>
        <pc:picChg chg="mod">
          <ac:chgData name="Héctor Cañeque Rufo" userId="6da3b7e2-2289-4c25-b14d-207ec07af19d" providerId="ADAL" clId="{495F2243-7A7C-4B18-A6AD-E5E11BECB84D}" dt="2024-01-10T15:06:13.355" v="1671" actId="1036"/>
          <ac:picMkLst>
            <pc:docMk/>
            <pc:sldMk cId="2134677172" sldId="261"/>
            <ac:picMk id="10" creationId="{2A8E2CC7-5BA7-5D29-53A4-5730BFE9F980}"/>
          </ac:picMkLst>
        </pc:picChg>
        <pc:picChg chg="mod">
          <ac:chgData name="Héctor Cañeque Rufo" userId="6da3b7e2-2289-4c25-b14d-207ec07af19d" providerId="ADAL" clId="{495F2243-7A7C-4B18-A6AD-E5E11BECB84D}" dt="2024-01-10T15:06:32.760" v="1695" actId="1036"/>
          <ac:picMkLst>
            <pc:docMk/>
            <pc:sldMk cId="2134677172" sldId="261"/>
            <ac:picMk id="15" creationId="{D43D65F3-E438-DA6E-27F5-450D605E6605}"/>
          </ac:picMkLst>
        </pc:picChg>
        <pc:picChg chg="mod">
          <ac:chgData name="Héctor Cañeque Rufo" userId="6da3b7e2-2289-4c25-b14d-207ec07af19d" providerId="ADAL" clId="{495F2243-7A7C-4B18-A6AD-E5E11BECB84D}" dt="2024-01-10T15:07:29.741" v="1729" actId="1038"/>
          <ac:picMkLst>
            <pc:docMk/>
            <pc:sldMk cId="2134677172" sldId="261"/>
            <ac:picMk id="16" creationId="{F34DD8E2-1306-4381-1EE7-407C5CA8AF92}"/>
          </ac:picMkLst>
        </pc:picChg>
        <pc:picChg chg="del">
          <ac:chgData name="Héctor Cañeque Rufo" userId="6da3b7e2-2289-4c25-b14d-207ec07af19d" providerId="ADAL" clId="{495F2243-7A7C-4B18-A6AD-E5E11BECB84D}" dt="2024-01-10T15:05:59.444" v="1649" actId="478"/>
          <ac:picMkLst>
            <pc:docMk/>
            <pc:sldMk cId="2134677172" sldId="261"/>
            <ac:picMk id="20" creationId="{FB61C11C-49FF-71D1-B281-A4CAB7515C0F}"/>
          </ac:picMkLst>
        </pc:picChg>
      </pc:sldChg>
    </pc:docChg>
  </pc:docChgLst>
  <pc:docChgLst>
    <pc:chgData name="Héctor Cañeque Rufo" userId="6da3b7e2-2289-4c25-b14d-207ec07af19d" providerId="ADAL" clId="{9ACB9FC0-9ACE-499D-AE96-7F9F2C1237D4}"/>
    <pc:docChg chg="custSel modSld">
      <pc:chgData name="Héctor Cañeque Rufo" userId="6da3b7e2-2289-4c25-b14d-207ec07af19d" providerId="ADAL" clId="{9ACB9FC0-9ACE-499D-AE96-7F9F2C1237D4}" dt="2024-03-06T11:18:08.452" v="91" actId="1035"/>
      <pc:docMkLst>
        <pc:docMk/>
      </pc:docMkLst>
      <pc:sldChg chg="addSp delSp modSp mod">
        <pc:chgData name="Héctor Cañeque Rufo" userId="6da3b7e2-2289-4c25-b14d-207ec07af19d" providerId="ADAL" clId="{9ACB9FC0-9ACE-499D-AE96-7F9F2C1237D4}" dt="2024-03-06T11:18:08.452" v="91" actId="1035"/>
        <pc:sldMkLst>
          <pc:docMk/>
          <pc:sldMk cId="4077600714" sldId="260"/>
        </pc:sldMkLst>
        <pc:spChg chg="mod">
          <ac:chgData name="Héctor Cañeque Rufo" userId="6da3b7e2-2289-4c25-b14d-207ec07af19d" providerId="ADAL" clId="{9ACB9FC0-9ACE-499D-AE96-7F9F2C1237D4}" dt="2024-03-06T11:18:08.452" v="91" actId="1035"/>
          <ac:spMkLst>
            <pc:docMk/>
            <pc:sldMk cId="4077600714" sldId="260"/>
            <ac:spMk id="6" creationId="{CCCB4646-A728-A888-3305-97837D3E0B25}"/>
          </ac:spMkLst>
        </pc:spChg>
        <pc:spChg chg="del">
          <ac:chgData name="Héctor Cañeque Rufo" userId="6da3b7e2-2289-4c25-b14d-207ec07af19d" providerId="ADAL" clId="{9ACB9FC0-9ACE-499D-AE96-7F9F2C1237D4}" dt="2024-03-06T11:17:31.186" v="78" actId="478"/>
          <ac:spMkLst>
            <pc:docMk/>
            <pc:sldMk cId="4077600714" sldId="260"/>
            <ac:spMk id="9" creationId="{4BC95A2C-5FF6-9E37-6DAA-5B9B3031F035}"/>
          </ac:spMkLst>
        </pc:spChg>
        <pc:spChg chg="del">
          <ac:chgData name="Héctor Cañeque Rufo" userId="6da3b7e2-2289-4c25-b14d-207ec07af19d" providerId="ADAL" clId="{9ACB9FC0-9ACE-499D-AE96-7F9F2C1237D4}" dt="2024-03-06T11:17:31.186" v="78" actId="478"/>
          <ac:spMkLst>
            <pc:docMk/>
            <pc:sldMk cId="4077600714" sldId="260"/>
            <ac:spMk id="10" creationId="{FFEB6301-8807-5A4E-D6D6-9C32376834DE}"/>
          </ac:spMkLst>
        </pc:spChg>
        <pc:spChg chg="del">
          <ac:chgData name="Héctor Cañeque Rufo" userId="6da3b7e2-2289-4c25-b14d-207ec07af19d" providerId="ADAL" clId="{9ACB9FC0-9ACE-499D-AE96-7F9F2C1237D4}" dt="2024-03-06T11:17:31.186" v="78" actId="478"/>
          <ac:spMkLst>
            <pc:docMk/>
            <pc:sldMk cId="4077600714" sldId="260"/>
            <ac:spMk id="11" creationId="{A86FCDD8-B990-C707-5233-5A1EDC34566D}"/>
          </ac:spMkLst>
        </pc:spChg>
        <pc:spChg chg="del">
          <ac:chgData name="Héctor Cañeque Rufo" userId="6da3b7e2-2289-4c25-b14d-207ec07af19d" providerId="ADAL" clId="{9ACB9FC0-9ACE-499D-AE96-7F9F2C1237D4}" dt="2024-03-06T11:17:31.186" v="78" actId="478"/>
          <ac:spMkLst>
            <pc:docMk/>
            <pc:sldMk cId="4077600714" sldId="260"/>
            <ac:spMk id="12" creationId="{18119F38-22E2-D2DA-D091-115E95A1845D}"/>
          </ac:spMkLst>
        </pc:spChg>
        <pc:picChg chg="add mod ord">
          <ac:chgData name="Héctor Cañeque Rufo" userId="6da3b7e2-2289-4c25-b14d-207ec07af19d" providerId="ADAL" clId="{9ACB9FC0-9ACE-499D-AE96-7F9F2C1237D4}" dt="2024-03-06T11:17:18.959" v="76" actId="167"/>
          <ac:picMkLst>
            <pc:docMk/>
            <pc:sldMk cId="4077600714" sldId="260"/>
            <ac:picMk id="3" creationId="{7E5BB1FB-FA84-D524-2CCD-F8D044273219}"/>
          </ac:picMkLst>
        </pc:picChg>
        <pc:picChg chg="del">
          <ac:chgData name="Héctor Cañeque Rufo" userId="6da3b7e2-2289-4c25-b14d-207ec07af19d" providerId="ADAL" clId="{9ACB9FC0-9ACE-499D-AE96-7F9F2C1237D4}" dt="2024-03-06T11:17:23.619" v="77" actId="478"/>
          <ac:picMkLst>
            <pc:docMk/>
            <pc:sldMk cId="4077600714" sldId="260"/>
            <ac:picMk id="8" creationId="{F927FB93-DE59-6CE2-65A9-0883773D4F0A}"/>
          </ac:picMkLst>
        </pc:picChg>
      </pc:sldChg>
    </pc:docChg>
  </pc:docChgLst>
  <pc:docChgLst>
    <pc:chgData name="Héctor Cañeque Rufo" userId="6da3b7e2-2289-4c25-b14d-207ec07af19d" providerId="ADAL" clId="{3C2A7719-56EA-4658-A9FA-11DDA14036B1}"/>
    <pc:docChg chg="undo custSel modSld">
      <pc:chgData name="Héctor Cañeque Rufo" userId="6da3b7e2-2289-4c25-b14d-207ec07af19d" providerId="ADAL" clId="{3C2A7719-56EA-4658-A9FA-11DDA14036B1}" dt="2024-01-17T16:40:36.739" v="395" actId="14100"/>
      <pc:docMkLst>
        <pc:docMk/>
      </pc:docMkLst>
      <pc:sldChg chg="addSp delSp modSp mod">
        <pc:chgData name="Héctor Cañeque Rufo" userId="6da3b7e2-2289-4c25-b14d-207ec07af19d" providerId="ADAL" clId="{3C2A7719-56EA-4658-A9FA-11DDA14036B1}" dt="2024-01-17T16:40:36.739" v="395" actId="14100"/>
        <pc:sldMkLst>
          <pc:docMk/>
          <pc:sldMk cId="4077600714" sldId="260"/>
        </pc:sldMkLst>
        <pc:spChg chg="add del mod">
          <ac:chgData name="Héctor Cañeque Rufo" userId="6da3b7e2-2289-4c25-b14d-207ec07af19d" providerId="ADAL" clId="{3C2A7719-56EA-4658-A9FA-11DDA14036B1}" dt="2024-01-17T16:35:03.625" v="100" actId="478"/>
          <ac:spMkLst>
            <pc:docMk/>
            <pc:sldMk cId="4077600714" sldId="260"/>
            <ac:spMk id="3" creationId="{84ED0F17-DFCC-DA4A-76D5-FC14DC3D6E31}"/>
          </ac:spMkLst>
        </pc:spChg>
        <pc:spChg chg="add mod">
          <ac:chgData name="Héctor Cañeque Rufo" userId="6da3b7e2-2289-4c25-b14d-207ec07af19d" providerId="ADAL" clId="{3C2A7719-56EA-4658-A9FA-11DDA14036B1}" dt="2024-01-17T16:38:32.790" v="252" actId="164"/>
          <ac:spMkLst>
            <pc:docMk/>
            <pc:sldMk cId="4077600714" sldId="260"/>
            <ac:spMk id="5" creationId="{4062DF7B-554A-80FF-4FF2-3BF3DA7BF365}"/>
          </ac:spMkLst>
        </pc:spChg>
        <pc:spChg chg="mod">
          <ac:chgData name="Héctor Cañeque Rufo" userId="6da3b7e2-2289-4c25-b14d-207ec07af19d" providerId="ADAL" clId="{3C2A7719-56EA-4658-A9FA-11DDA14036B1}" dt="2024-01-17T16:40:36.739" v="395" actId="14100"/>
          <ac:spMkLst>
            <pc:docMk/>
            <pc:sldMk cId="4077600714" sldId="260"/>
            <ac:spMk id="6" creationId="{CCCB4646-A728-A888-3305-97837D3E0B25}"/>
          </ac:spMkLst>
        </pc:spChg>
        <pc:spChg chg="add mod">
          <ac:chgData name="Héctor Cañeque Rufo" userId="6da3b7e2-2289-4c25-b14d-207ec07af19d" providerId="ADAL" clId="{3C2A7719-56EA-4658-A9FA-11DDA14036B1}" dt="2024-01-17T16:38:32.790" v="252" actId="164"/>
          <ac:spMkLst>
            <pc:docMk/>
            <pc:sldMk cId="4077600714" sldId="260"/>
            <ac:spMk id="9" creationId="{4BC95A2C-5FF6-9E37-6DAA-5B9B3031F035}"/>
          </ac:spMkLst>
        </pc:spChg>
        <pc:spChg chg="add mod">
          <ac:chgData name="Héctor Cañeque Rufo" userId="6da3b7e2-2289-4c25-b14d-207ec07af19d" providerId="ADAL" clId="{3C2A7719-56EA-4658-A9FA-11DDA14036B1}" dt="2024-01-17T16:38:32.790" v="252" actId="164"/>
          <ac:spMkLst>
            <pc:docMk/>
            <pc:sldMk cId="4077600714" sldId="260"/>
            <ac:spMk id="10" creationId="{FFEB6301-8807-5A4E-D6D6-9C32376834DE}"/>
          </ac:spMkLst>
        </pc:spChg>
        <pc:spChg chg="add mod">
          <ac:chgData name="Héctor Cañeque Rufo" userId="6da3b7e2-2289-4c25-b14d-207ec07af19d" providerId="ADAL" clId="{3C2A7719-56EA-4658-A9FA-11DDA14036B1}" dt="2024-01-17T16:38:32.790" v="252" actId="164"/>
          <ac:spMkLst>
            <pc:docMk/>
            <pc:sldMk cId="4077600714" sldId="260"/>
            <ac:spMk id="11" creationId="{A86FCDD8-B990-C707-5233-5A1EDC34566D}"/>
          </ac:spMkLst>
        </pc:spChg>
        <pc:spChg chg="add mod">
          <ac:chgData name="Héctor Cañeque Rufo" userId="6da3b7e2-2289-4c25-b14d-207ec07af19d" providerId="ADAL" clId="{3C2A7719-56EA-4658-A9FA-11DDA14036B1}" dt="2024-01-17T16:38:32.790" v="252" actId="164"/>
          <ac:spMkLst>
            <pc:docMk/>
            <pc:sldMk cId="4077600714" sldId="260"/>
            <ac:spMk id="12" creationId="{18119F38-22E2-D2DA-D091-115E95A1845D}"/>
          </ac:spMkLst>
        </pc:spChg>
        <pc:spChg chg="add mod">
          <ac:chgData name="Héctor Cañeque Rufo" userId="6da3b7e2-2289-4c25-b14d-207ec07af19d" providerId="ADAL" clId="{3C2A7719-56EA-4658-A9FA-11DDA14036B1}" dt="2024-01-17T16:38:32.790" v="252" actId="164"/>
          <ac:spMkLst>
            <pc:docMk/>
            <pc:sldMk cId="4077600714" sldId="260"/>
            <ac:spMk id="13" creationId="{EB178931-0247-A925-41C2-F61EAB08EED4}"/>
          </ac:spMkLst>
        </pc:spChg>
        <pc:grpChg chg="add mod">
          <ac:chgData name="Héctor Cañeque Rufo" userId="6da3b7e2-2289-4c25-b14d-207ec07af19d" providerId="ADAL" clId="{3C2A7719-56EA-4658-A9FA-11DDA14036B1}" dt="2024-01-17T16:38:38.643" v="321" actId="1035"/>
          <ac:grpSpMkLst>
            <pc:docMk/>
            <pc:sldMk cId="4077600714" sldId="260"/>
            <ac:grpSpMk id="14" creationId="{1ED116A4-B5F2-291A-AB3F-2825CD35CC13}"/>
          </ac:grpSpMkLst>
        </pc:grpChg>
        <pc:picChg chg="add mod">
          <ac:chgData name="Héctor Cañeque Rufo" userId="6da3b7e2-2289-4c25-b14d-207ec07af19d" providerId="ADAL" clId="{3C2A7719-56EA-4658-A9FA-11DDA14036B1}" dt="2024-01-17T16:34:22.140" v="61" actId="1037"/>
          <ac:picMkLst>
            <pc:docMk/>
            <pc:sldMk cId="4077600714" sldId="260"/>
            <ac:picMk id="2" creationId="{983E18B0-3843-AF17-78F5-BCCB1A4278E2}"/>
          </ac:picMkLst>
        </pc:picChg>
        <pc:picChg chg="add del mod">
          <ac:chgData name="Héctor Cañeque Rufo" userId="6da3b7e2-2289-4c25-b14d-207ec07af19d" providerId="ADAL" clId="{3C2A7719-56EA-4658-A9FA-11DDA14036B1}" dt="2024-01-17T16:35:01.736" v="99" actId="478"/>
          <ac:picMkLst>
            <pc:docMk/>
            <pc:sldMk cId="4077600714" sldId="260"/>
            <ac:picMk id="4" creationId="{82BAB099-7CC5-48F2-E550-F9B2C232547D}"/>
          </ac:picMkLst>
        </pc:picChg>
        <pc:picChg chg="mod">
          <ac:chgData name="Héctor Cañeque Rufo" userId="6da3b7e2-2289-4c25-b14d-207ec07af19d" providerId="ADAL" clId="{3C2A7719-56EA-4658-A9FA-11DDA14036B1}" dt="2024-01-17T16:38:32.790" v="252" actId="164"/>
          <ac:picMkLst>
            <pc:docMk/>
            <pc:sldMk cId="4077600714" sldId="260"/>
            <ac:picMk id="7" creationId="{3701548B-1FAF-0049-1EF4-8CD2F44AFE36}"/>
          </ac:picMkLst>
        </pc:picChg>
        <pc:picChg chg="add mod">
          <ac:chgData name="Héctor Cañeque Rufo" userId="6da3b7e2-2289-4c25-b14d-207ec07af19d" providerId="ADAL" clId="{3C2A7719-56EA-4658-A9FA-11DDA14036B1}" dt="2024-01-17T16:38:32.790" v="252" actId="164"/>
          <ac:picMkLst>
            <pc:docMk/>
            <pc:sldMk cId="4077600714" sldId="260"/>
            <ac:picMk id="8" creationId="{F927FB93-DE59-6CE2-65A9-0883773D4F0A}"/>
          </ac:picMkLst>
        </pc:picChg>
      </pc:sldChg>
    </pc:docChg>
  </pc:docChgLst>
  <pc:docChgLst>
    <pc:chgData name="Héctor Cañeque Rufo" userId="6da3b7e2-2289-4c25-b14d-207ec07af19d" providerId="ADAL" clId="{110670A2-31F1-46D6-B9C0-FFC839AF2B13}"/>
    <pc:docChg chg="undo custSel addSld delSld modSld">
      <pc:chgData name="Héctor Cañeque Rufo" userId="6da3b7e2-2289-4c25-b14d-207ec07af19d" providerId="ADAL" clId="{110670A2-31F1-46D6-B9C0-FFC839AF2B13}" dt="2023-10-25T13:02:40.495" v="6496" actId="20577"/>
      <pc:docMkLst>
        <pc:docMk/>
      </pc:docMkLst>
      <pc:sldChg chg="addSp delSp modSp new del mod">
        <pc:chgData name="Héctor Cañeque Rufo" userId="6da3b7e2-2289-4c25-b14d-207ec07af19d" providerId="ADAL" clId="{110670A2-31F1-46D6-B9C0-FFC839AF2B13}" dt="2023-10-11T16:40:26.239" v="5500" actId="2696"/>
        <pc:sldMkLst>
          <pc:docMk/>
          <pc:sldMk cId="1548558497" sldId="256"/>
        </pc:sldMkLst>
        <pc:spChg chg="del">
          <ac:chgData name="Héctor Cañeque Rufo" userId="6da3b7e2-2289-4c25-b14d-207ec07af19d" providerId="ADAL" clId="{110670A2-31F1-46D6-B9C0-FFC839AF2B13}" dt="2023-10-11T15:18:41.463" v="1" actId="478"/>
          <ac:spMkLst>
            <pc:docMk/>
            <pc:sldMk cId="1548558497" sldId="256"/>
            <ac:spMk id="2" creationId="{36513856-BF2C-AADE-A2D0-18E43A1D7DE1}"/>
          </ac:spMkLst>
        </pc:spChg>
        <pc:spChg chg="del">
          <ac:chgData name="Héctor Cañeque Rufo" userId="6da3b7e2-2289-4c25-b14d-207ec07af19d" providerId="ADAL" clId="{110670A2-31F1-46D6-B9C0-FFC839AF2B13}" dt="2023-10-11T15:18:43.229" v="2" actId="478"/>
          <ac:spMkLst>
            <pc:docMk/>
            <pc:sldMk cId="1548558497" sldId="256"/>
            <ac:spMk id="3" creationId="{C35EA3E6-2D73-CC15-850E-13ED33B86DC7}"/>
          </ac:spMkLst>
        </pc:spChg>
        <pc:spChg chg="add del mod">
          <ac:chgData name="Héctor Cañeque Rufo" userId="6da3b7e2-2289-4c25-b14d-207ec07af19d" providerId="ADAL" clId="{110670A2-31F1-46D6-B9C0-FFC839AF2B13}" dt="2023-10-11T16:04:58.831" v="2848" actId="478"/>
          <ac:spMkLst>
            <pc:docMk/>
            <pc:sldMk cId="1548558497" sldId="256"/>
            <ac:spMk id="8" creationId="{B4672C73-45A6-D5F3-9611-654ED7B653F6}"/>
          </ac:spMkLst>
        </pc:spChg>
        <pc:spChg chg="add mod">
          <ac:chgData name="Héctor Cañeque Rufo" userId="6da3b7e2-2289-4c25-b14d-207ec07af19d" providerId="ADAL" clId="{110670A2-31F1-46D6-B9C0-FFC839AF2B13}" dt="2023-10-11T16:39:22.760" v="5485" actId="1036"/>
          <ac:spMkLst>
            <pc:docMk/>
            <pc:sldMk cId="1548558497" sldId="256"/>
            <ac:spMk id="21" creationId="{54826E5E-9298-8F37-8F51-631DB6F6993B}"/>
          </ac:spMkLst>
        </pc:spChg>
        <pc:spChg chg="add del mod">
          <ac:chgData name="Héctor Cañeque Rufo" userId="6da3b7e2-2289-4c25-b14d-207ec07af19d" providerId="ADAL" clId="{110670A2-31F1-46D6-B9C0-FFC839AF2B13}" dt="2023-10-11T16:09:27.234" v="3030" actId="478"/>
          <ac:spMkLst>
            <pc:docMk/>
            <pc:sldMk cId="1548558497" sldId="256"/>
            <ac:spMk id="22" creationId="{6A807A99-5770-26EF-83F9-A6A8D108BAE3}"/>
          </ac:spMkLst>
        </pc:spChg>
        <pc:spChg chg="add mod">
          <ac:chgData name="Héctor Cañeque Rufo" userId="6da3b7e2-2289-4c25-b14d-207ec07af19d" providerId="ADAL" clId="{110670A2-31F1-46D6-B9C0-FFC839AF2B13}" dt="2023-10-11T16:13:10.661" v="3406" actId="1035"/>
          <ac:spMkLst>
            <pc:docMk/>
            <pc:sldMk cId="1548558497" sldId="256"/>
            <ac:spMk id="23" creationId="{61A91876-C028-5567-9581-C18C4AAD189F}"/>
          </ac:spMkLst>
        </pc:spChg>
        <pc:spChg chg="add mod">
          <ac:chgData name="Héctor Cañeque Rufo" userId="6da3b7e2-2289-4c25-b14d-207ec07af19d" providerId="ADAL" clId="{110670A2-31F1-46D6-B9C0-FFC839AF2B13}" dt="2023-10-11T16:13:10.661" v="3406" actId="1035"/>
          <ac:spMkLst>
            <pc:docMk/>
            <pc:sldMk cId="1548558497" sldId="256"/>
            <ac:spMk id="28" creationId="{07816D40-2BF5-86D0-F3D5-C652998944A5}"/>
          </ac:spMkLst>
        </pc:spChg>
        <pc:spChg chg="add mod">
          <ac:chgData name="Héctor Cañeque Rufo" userId="6da3b7e2-2289-4c25-b14d-207ec07af19d" providerId="ADAL" clId="{110670A2-31F1-46D6-B9C0-FFC839AF2B13}" dt="2023-10-11T16:13:10.661" v="3406" actId="1035"/>
          <ac:spMkLst>
            <pc:docMk/>
            <pc:sldMk cId="1548558497" sldId="256"/>
            <ac:spMk id="29" creationId="{7ADF9F89-10B6-523E-A1BB-7D5C4D92B105}"/>
          </ac:spMkLst>
        </pc:spChg>
        <pc:spChg chg="add mod">
          <ac:chgData name="Héctor Cañeque Rufo" userId="6da3b7e2-2289-4c25-b14d-207ec07af19d" providerId="ADAL" clId="{110670A2-31F1-46D6-B9C0-FFC839AF2B13}" dt="2023-10-11T16:14:13.562" v="3531" actId="20577"/>
          <ac:spMkLst>
            <pc:docMk/>
            <pc:sldMk cId="1548558497" sldId="256"/>
            <ac:spMk id="32" creationId="{FD6EED3D-3261-2688-D45D-4A0384C75B18}"/>
          </ac:spMkLst>
        </pc:spChg>
        <pc:spChg chg="add mod">
          <ac:chgData name="Héctor Cañeque Rufo" userId="6da3b7e2-2289-4c25-b14d-207ec07af19d" providerId="ADAL" clId="{110670A2-31F1-46D6-B9C0-FFC839AF2B13}" dt="2023-10-11T16:14:18.202" v="3532" actId="20577"/>
          <ac:spMkLst>
            <pc:docMk/>
            <pc:sldMk cId="1548558497" sldId="256"/>
            <ac:spMk id="33" creationId="{CA97694A-815A-DF62-3C23-C1BC81327F75}"/>
          </ac:spMkLst>
        </pc:spChg>
        <pc:spChg chg="add mod">
          <ac:chgData name="Héctor Cañeque Rufo" userId="6da3b7e2-2289-4c25-b14d-207ec07af19d" providerId="ADAL" clId="{110670A2-31F1-46D6-B9C0-FFC839AF2B13}" dt="2023-10-11T16:14:22.396" v="3533" actId="20577"/>
          <ac:spMkLst>
            <pc:docMk/>
            <pc:sldMk cId="1548558497" sldId="256"/>
            <ac:spMk id="34" creationId="{6E246F61-EE4C-3889-1616-DE67FD3EA238}"/>
          </ac:spMkLst>
        </pc:spChg>
        <pc:grpChg chg="add del mod">
          <ac:chgData name="Héctor Cañeque Rufo" userId="6da3b7e2-2289-4c25-b14d-207ec07af19d" providerId="ADAL" clId="{110670A2-31F1-46D6-B9C0-FFC839AF2B13}" dt="2023-10-11T15:57:45.312" v="2846" actId="165"/>
          <ac:grpSpMkLst>
            <pc:docMk/>
            <pc:sldMk cId="1548558497" sldId="256"/>
            <ac:grpSpMk id="14" creationId="{2C32A51F-C84C-F92E-9425-75A881BF861E}"/>
          </ac:grpSpMkLst>
        </pc:grpChg>
        <pc:grpChg chg="add del mod">
          <ac:chgData name="Héctor Cañeque Rufo" userId="6da3b7e2-2289-4c25-b14d-207ec07af19d" providerId="ADAL" clId="{110670A2-31F1-46D6-B9C0-FFC839AF2B13}" dt="2023-10-11T15:38:41.921" v="1151" actId="165"/>
          <ac:grpSpMkLst>
            <pc:docMk/>
            <pc:sldMk cId="1548558497" sldId="256"/>
            <ac:grpSpMk id="15" creationId="{4DD2CD24-3E37-1F71-EC08-06FDF46C7344}"/>
          </ac:grpSpMkLst>
        </pc:grpChg>
        <pc:grpChg chg="add del mod">
          <ac:chgData name="Héctor Cañeque Rufo" userId="6da3b7e2-2289-4c25-b14d-207ec07af19d" providerId="ADAL" clId="{110670A2-31F1-46D6-B9C0-FFC839AF2B13}" dt="2023-10-11T16:07:36.376" v="2983" actId="165"/>
          <ac:grpSpMkLst>
            <pc:docMk/>
            <pc:sldMk cId="1548558497" sldId="256"/>
            <ac:grpSpMk id="20" creationId="{1D3C2E6B-EC4A-8F30-1DF8-A61E4987D751}"/>
          </ac:grpSpMkLst>
        </pc:grpChg>
        <pc:grpChg chg="add mod">
          <ac:chgData name="Héctor Cañeque Rufo" userId="6da3b7e2-2289-4c25-b14d-207ec07af19d" providerId="ADAL" clId="{110670A2-31F1-46D6-B9C0-FFC839AF2B13}" dt="2023-10-11T16:14:05.145" v="3530" actId="1036"/>
          <ac:grpSpMkLst>
            <pc:docMk/>
            <pc:sldMk cId="1548558497" sldId="256"/>
            <ac:grpSpMk id="31" creationId="{69780F9D-DEA0-C13A-97B9-00D6E418C510}"/>
          </ac:grpSpMkLst>
        </pc:grpChg>
        <pc:picChg chg="add del">
          <ac:chgData name="Héctor Cañeque Rufo" userId="6da3b7e2-2289-4c25-b14d-207ec07af19d" providerId="ADAL" clId="{110670A2-31F1-46D6-B9C0-FFC839AF2B13}" dt="2023-10-11T15:20:16.290" v="4" actId="478"/>
          <ac:picMkLst>
            <pc:docMk/>
            <pc:sldMk cId="1548558497" sldId="256"/>
            <ac:picMk id="4" creationId="{BD2FF96F-4572-04B5-6727-AD1477A8A4E1}"/>
          </ac:picMkLst>
        </pc:picChg>
        <pc:picChg chg="add del mod">
          <ac:chgData name="Héctor Cañeque Rufo" userId="6da3b7e2-2289-4c25-b14d-207ec07af19d" providerId="ADAL" clId="{110670A2-31F1-46D6-B9C0-FFC839AF2B13}" dt="2023-10-11T15:20:24.713" v="6" actId="478"/>
          <ac:picMkLst>
            <pc:docMk/>
            <pc:sldMk cId="1548558497" sldId="256"/>
            <ac:picMk id="5" creationId="{F792F2E2-B1E6-6990-E291-9EC8E656DE91}"/>
          </ac:picMkLst>
        </pc:picChg>
        <pc:picChg chg="add del mod topLvl">
          <ac:chgData name="Héctor Cañeque Rufo" userId="6da3b7e2-2289-4c25-b14d-207ec07af19d" providerId="ADAL" clId="{110670A2-31F1-46D6-B9C0-FFC839AF2B13}" dt="2023-10-11T16:09:24.184" v="3029" actId="478"/>
          <ac:picMkLst>
            <pc:docMk/>
            <pc:sldMk cId="1548558497" sldId="256"/>
            <ac:picMk id="6" creationId="{C47E6BA4-4479-B515-6C61-9218E35EA25F}"/>
          </ac:picMkLst>
        </pc:picChg>
        <pc:picChg chg="add del mod ord topLvl">
          <ac:chgData name="Héctor Cañeque Rufo" userId="6da3b7e2-2289-4c25-b14d-207ec07af19d" providerId="ADAL" clId="{110670A2-31F1-46D6-B9C0-FFC839AF2B13}" dt="2023-10-11T16:39:15.965" v="5441" actId="478"/>
          <ac:picMkLst>
            <pc:docMk/>
            <pc:sldMk cId="1548558497" sldId="256"/>
            <ac:picMk id="7" creationId="{265DDCD2-73FD-FCC3-6978-A9DF6E8F5A43}"/>
          </ac:picMkLst>
        </pc:picChg>
        <pc:picChg chg="add del mod topLvl">
          <ac:chgData name="Héctor Cañeque Rufo" userId="6da3b7e2-2289-4c25-b14d-207ec07af19d" providerId="ADAL" clId="{110670A2-31F1-46D6-B9C0-FFC839AF2B13}" dt="2023-10-11T15:43:46.364" v="2033" actId="478"/>
          <ac:picMkLst>
            <pc:docMk/>
            <pc:sldMk cId="1548558497" sldId="256"/>
            <ac:picMk id="9" creationId="{CD486E9F-B14D-128D-67EA-C89502C8C4FC}"/>
          </ac:picMkLst>
        </pc:picChg>
        <pc:picChg chg="add del mod topLvl">
          <ac:chgData name="Héctor Cañeque Rufo" userId="6da3b7e2-2289-4c25-b14d-207ec07af19d" providerId="ADAL" clId="{110670A2-31F1-46D6-B9C0-FFC839AF2B13}" dt="2023-10-11T15:43:46.364" v="2033" actId="478"/>
          <ac:picMkLst>
            <pc:docMk/>
            <pc:sldMk cId="1548558497" sldId="256"/>
            <ac:picMk id="10" creationId="{019B51A9-4B81-A68F-3C05-28125A6BA674}"/>
          </ac:picMkLst>
        </pc:picChg>
        <pc:picChg chg="add del mod">
          <ac:chgData name="Héctor Cañeque Rufo" userId="6da3b7e2-2289-4c25-b14d-207ec07af19d" providerId="ADAL" clId="{110670A2-31F1-46D6-B9C0-FFC839AF2B13}" dt="2023-10-11T15:27:29.296" v="433" actId="478"/>
          <ac:picMkLst>
            <pc:docMk/>
            <pc:sldMk cId="1548558497" sldId="256"/>
            <ac:picMk id="11" creationId="{4F0C9D90-3D95-215C-0833-ABD3D4599BAD}"/>
          </ac:picMkLst>
        </pc:picChg>
        <pc:picChg chg="add mod topLvl">
          <ac:chgData name="Héctor Cañeque Rufo" userId="6da3b7e2-2289-4c25-b14d-207ec07af19d" providerId="ADAL" clId="{110670A2-31F1-46D6-B9C0-FFC839AF2B13}" dt="2023-10-11T16:13:10.661" v="3406" actId="1035"/>
          <ac:picMkLst>
            <pc:docMk/>
            <pc:sldMk cId="1548558497" sldId="256"/>
            <ac:picMk id="12" creationId="{9C80E917-8625-BD51-DB49-917151A4F2D2}"/>
          </ac:picMkLst>
        </pc:picChg>
        <pc:picChg chg="add mod topLvl">
          <ac:chgData name="Héctor Cañeque Rufo" userId="6da3b7e2-2289-4c25-b14d-207ec07af19d" providerId="ADAL" clId="{110670A2-31F1-46D6-B9C0-FFC839AF2B13}" dt="2023-10-11T16:13:46.395" v="3498" actId="1036"/>
          <ac:picMkLst>
            <pc:docMk/>
            <pc:sldMk cId="1548558497" sldId="256"/>
            <ac:picMk id="13" creationId="{7A3A51E2-91FA-7E94-C135-E09B6717C731}"/>
          </ac:picMkLst>
        </pc:picChg>
        <pc:picChg chg="add del mod">
          <ac:chgData name="Héctor Cañeque Rufo" userId="6da3b7e2-2289-4c25-b14d-207ec07af19d" providerId="ADAL" clId="{110670A2-31F1-46D6-B9C0-FFC839AF2B13}" dt="2023-10-11T15:40:54.284" v="1515" actId="478"/>
          <ac:picMkLst>
            <pc:docMk/>
            <pc:sldMk cId="1548558497" sldId="256"/>
            <ac:picMk id="16" creationId="{14258566-C446-E3CB-4400-F1338E275B30}"/>
          </ac:picMkLst>
        </pc:picChg>
        <pc:picChg chg="add del mod">
          <ac:chgData name="Héctor Cañeque Rufo" userId="6da3b7e2-2289-4c25-b14d-207ec07af19d" providerId="ADAL" clId="{110670A2-31F1-46D6-B9C0-FFC839AF2B13}" dt="2023-10-11T15:50:18.587" v="2234" actId="478"/>
          <ac:picMkLst>
            <pc:docMk/>
            <pc:sldMk cId="1548558497" sldId="256"/>
            <ac:picMk id="17" creationId="{6F4125AB-F59D-E197-60B7-1666E18F633A}"/>
          </ac:picMkLst>
        </pc:picChg>
        <pc:picChg chg="add mod ord topLvl">
          <ac:chgData name="Héctor Cañeque Rufo" userId="6da3b7e2-2289-4c25-b14d-207ec07af19d" providerId="ADAL" clId="{110670A2-31F1-46D6-B9C0-FFC839AF2B13}" dt="2023-10-11T16:13:10.661" v="3406" actId="1035"/>
          <ac:picMkLst>
            <pc:docMk/>
            <pc:sldMk cId="1548558497" sldId="256"/>
            <ac:picMk id="18" creationId="{DA55C7F4-6D6B-A553-D147-77A365D4BCF8}"/>
          </ac:picMkLst>
        </pc:picChg>
        <pc:picChg chg="add mod topLvl">
          <ac:chgData name="Héctor Cañeque Rufo" userId="6da3b7e2-2289-4c25-b14d-207ec07af19d" providerId="ADAL" clId="{110670A2-31F1-46D6-B9C0-FFC839AF2B13}" dt="2023-10-11T16:13:46.395" v="3498" actId="1036"/>
          <ac:picMkLst>
            <pc:docMk/>
            <pc:sldMk cId="1548558497" sldId="256"/>
            <ac:picMk id="19" creationId="{9724040B-0196-9AD6-E635-0094BB96A211}"/>
          </ac:picMkLst>
        </pc:picChg>
        <pc:picChg chg="add mod modCrop">
          <ac:chgData name="Héctor Cañeque Rufo" userId="6da3b7e2-2289-4c25-b14d-207ec07af19d" providerId="ADAL" clId="{110670A2-31F1-46D6-B9C0-FFC839AF2B13}" dt="2023-10-11T16:11:25.817" v="3252" actId="164"/>
          <ac:picMkLst>
            <pc:docMk/>
            <pc:sldMk cId="1548558497" sldId="256"/>
            <ac:picMk id="24" creationId="{14033417-772B-A47C-5E24-843A3841337A}"/>
          </ac:picMkLst>
        </pc:picChg>
        <pc:picChg chg="add del mod">
          <ac:chgData name="Héctor Cañeque Rufo" userId="6da3b7e2-2289-4c25-b14d-207ec07af19d" providerId="ADAL" clId="{110670A2-31F1-46D6-B9C0-FFC839AF2B13}" dt="2023-10-11T16:07:17.962" v="2951" actId="478"/>
          <ac:picMkLst>
            <pc:docMk/>
            <pc:sldMk cId="1548558497" sldId="256"/>
            <ac:picMk id="25" creationId="{3EF07B93-FC20-88A2-95ED-B65F308D6B4D}"/>
          </ac:picMkLst>
        </pc:picChg>
        <pc:picChg chg="add mod ord modCrop">
          <ac:chgData name="Héctor Cañeque Rufo" userId="6da3b7e2-2289-4c25-b14d-207ec07af19d" providerId="ADAL" clId="{110670A2-31F1-46D6-B9C0-FFC839AF2B13}" dt="2023-10-11T16:13:58.630" v="3515" actId="1035"/>
          <ac:picMkLst>
            <pc:docMk/>
            <pc:sldMk cId="1548558497" sldId="256"/>
            <ac:picMk id="26" creationId="{F01FA171-A34E-7474-ED42-645951E30860}"/>
          </ac:picMkLst>
        </pc:picChg>
        <pc:picChg chg="add del mod modCrop">
          <ac:chgData name="Héctor Cañeque Rufo" userId="6da3b7e2-2289-4c25-b14d-207ec07af19d" providerId="ADAL" clId="{110670A2-31F1-46D6-B9C0-FFC839AF2B13}" dt="2023-10-11T16:08:33.227" v="3013" actId="478"/>
          <ac:picMkLst>
            <pc:docMk/>
            <pc:sldMk cId="1548558497" sldId="256"/>
            <ac:picMk id="27" creationId="{9DC0F0AC-182A-9687-9E49-69D3687BBC5D}"/>
          </ac:picMkLst>
        </pc:picChg>
        <pc:picChg chg="add mod modCrop">
          <ac:chgData name="Héctor Cañeque Rufo" userId="6da3b7e2-2289-4c25-b14d-207ec07af19d" providerId="ADAL" clId="{110670A2-31F1-46D6-B9C0-FFC839AF2B13}" dt="2023-10-11T16:11:25.817" v="3252" actId="164"/>
          <ac:picMkLst>
            <pc:docMk/>
            <pc:sldMk cId="1548558497" sldId="256"/>
            <ac:picMk id="30" creationId="{C7F547A5-E980-A8D1-DE02-60341C430CAD}"/>
          </ac:picMkLst>
        </pc:picChg>
        <pc:picChg chg="add mod">
          <ac:chgData name="Héctor Cañeque Rufo" userId="6da3b7e2-2289-4c25-b14d-207ec07af19d" providerId="ADAL" clId="{110670A2-31F1-46D6-B9C0-FFC839AF2B13}" dt="2023-10-11T16:39:12.575" v="5440" actId="1036"/>
          <ac:picMkLst>
            <pc:docMk/>
            <pc:sldMk cId="1548558497" sldId="256"/>
            <ac:picMk id="35" creationId="{E38F1110-B23C-D4BE-C81D-32B05127A5F5}"/>
          </ac:picMkLst>
        </pc:picChg>
      </pc:sldChg>
      <pc:sldChg chg="addSp delSp modSp add mod">
        <pc:chgData name="Héctor Cañeque Rufo" userId="6da3b7e2-2289-4c25-b14d-207ec07af19d" providerId="ADAL" clId="{110670A2-31F1-46D6-B9C0-FFC839AF2B13}" dt="2023-10-13T07:18:27.384" v="6269" actId="21"/>
        <pc:sldMkLst>
          <pc:docMk/>
          <pc:sldMk cId="3649846329" sldId="257"/>
        </pc:sldMkLst>
        <pc:spChg chg="add mod">
          <ac:chgData name="Héctor Cañeque Rufo" userId="6da3b7e2-2289-4c25-b14d-207ec07af19d" providerId="ADAL" clId="{110670A2-31F1-46D6-B9C0-FFC839AF2B13}" dt="2023-10-11T16:41:23.566" v="5572" actId="20577"/>
          <ac:spMkLst>
            <pc:docMk/>
            <pc:sldMk cId="3649846329" sldId="257"/>
            <ac:spMk id="2" creationId="{2803F996-BD38-4464-FA93-D50F1B72AF57}"/>
          </ac:spMkLst>
        </pc:spChg>
        <pc:spChg chg="add mod">
          <ac:chgData name="Héctor Cañeque Rufo" userId="6da3b7e2-2289-4c25-b14d-207ec07af19d" providerId="ADAL" clId="{110670A2-31F1-46D6-B9C0-FFC839AF2B13}" dt="2023-10-11T16:41:27.055" v="5573" actId="20577"/>
          <ac:spMkLst>
            <pc:docMk/>
            <pc:sldMk cId="3649846329" sldId="257"/>
            <ac:spMk id="3" creationId="{6796E5AE-8DD8-E698-D0E9-4745AE9B025E}"/>
          </ac:spMkLst>
        </pc:spChg>
        <pc:spChg chg="add mod">
          <ac:chgData name="Héctor Cañeque Rufo" userId="6da3b7e2-2289-4c25-b14d-207ec07af19d" providerId="ADAL" clId="{110670A2-31F1-46D6-B9C0-FFC839AF2B13}" dt="2023-10-13T06:51:06.108" v="5666" actId="1035"/>
          <ac:spMkLst>
            <pc:docMk/>
            <pc:sldMk cId="3649846329" sldId="257"/>
            <ac:spMk id="4" creationId="{93C1E1F6-630F-01A1-17F3-E572FF984990}"/>
          </ac:spMkLst>
        </pc:spChg>
        <pc:spChg chg="add mod">
          <ac:chgData name="Héctor Cañeque Rufo" userId="6da3b7e2-2289-4c25-b14d-207ec07af19d" providerId="ADAL" clId="{110670A2-31F1-46D6-B9C0-FFC839AF2B13}" dt="2023-10-13T06:51:06.108" v="5666" actId="1035"/>
          <ac:spMkLst>
            <pc:docMk/>
            <pc:sldMk cId="3649846329" sldId="257"/>
            <ac:spMk id="5" creationId="{35E75241-8090-BEB8-18D2-0F7DE932FC9D}"/>
          </ac:spMkLst>
        </pc:spChg>
        <pc:spChg chg="add del mod">
          <ac:chgData name="Héctor Cañeque Rufo" userId="6da3b7e2-2289-4c25-b14d-207ec07af19d" providerId="ADAL" clId="{110670A2-31F1-46D6-B9C0-FFC839AF2B13}" dt="2023-10-13T07:18:27.384" v="6269" actId="21"/>
          <ac:spMkLst>
            <pc:docMk/>
            <pc:sldMk cId="3649846329" sldId="257"/>
            <ac:spMk id="7" creationId="{285A3BA8-7582-AEC0-1963-0D63CBAEC572}"/>
          </ac:spMkLst>
        </pc:spChg>
        <pc:spChg chg="mod">
          <ac:chgData name="Héctor Cañeque Rufo" userId="6da3b7e2-2289-4c25-b14d-207ec07af19d" providerId="ADAL" clId="{110670A2-31F1-46D6-B9C0-FFC839AF2B13}" dt="2023-10-11T16:37:56.841" v="5192" actId="1036"/>
          <ac:spMkLst>
            <pc:docMk/>
            <pc:sldMk cId="3649846329" sldId="257"/>
            <ac:spMk id="14" creationId="{10C6D9CF-3F5C-E53D-D75E-29C87EB43404}"/>
          </ac:spMkLst>
        </pc:spChg>
        <pc:spChg chg="mod">
          <ac:chgData name="Héctor Cañeque Rufo" userId="6da3b7e2-2289-4c25-b14d-207ec07af19d" providerId="ADAL" clId="{110670A2-31F1-46D6-B9C0-FFC839AF2B13}" dt="2023-10-11T16:37:56.841" v="5192" actId="1036"/>
          <ac:spMkLst>
            <pc:docMk/>
            <pc:sldMk cId="3649846329" sldId="257"/>
            <ac:spMk id="15" creationId="{8E5B510E-19BB-AD1D-DC70-E1F78D6F7823}"/>
          </ac:spMkLst>
        </pc:spChg>
        <pc:spChg chg="mod">
          <ac:chgData name="Héctor Cañeque Rufo" userId="6da3b7e2-2289-4c25-b14d-207ec07af19d" providerId="ADAL" clId="{110670A2-31F1-46D6-B9C0-FFC839AF2B13}" dt="2023-10-11T16:37:56.841" v="5192" actId="1036"/>
          <ac:spMkLst>
            <pc:docMk/>
            <pc:sldMk cId="3649846329" sldId="257"/>
            <ac:spMk id="16" creationId="{2F1B9F47-CB02-8EBF-A84F-8545D677098D}"/>
          </ac:spMkLst>
        </pc:spChg>
        <pc:spChg chg="mod">
          <ac:chgData name="Héctor Cañeque Rufo" userId="6da3b7e2-2289-4c25-b14d-207ec07af19d" providerId="ADAL" clId="{110670A2-31F1-46D6-B9C0-FFC839AF2B13}" dt="2023-10-11T16:37:56.841" v="5192" actId="1036"/>
          <ac:spMkLst>
            <pc:docMk/>
            <pc:sldMk cId="3649846329" sldId="257"/>
            <ac:spMk id="17" creationId="{7E45102A-3117-940A-AFC2-2DACBC8D4AE4}"/>
          </ac:spMkLst>
        </pc:spChg>
        <pc:spChg chg="del">
          <ac:chgData name="Héctor Cañeque Rufo" userId="6da3b7e2-2289-4c25-b14d-207ec07af19d" providerId="ADAL" clId="{110670A2-31F1-46D6-B9C0-FFC839AF2B13}" dt="2023-10-11T16:19:48.207" v="3621" actId="478"/>
          <ac:spMkLst>
            <pc:docMk/>
            <pc:sldMk cId="3649846329" sldId="257"/>
            <ac:spMk id="21" creationId="{54826E5E-9298-8F37-8F51-631DB6F6993B}"/>
          </ac:spMkLst>
        </pc:spChg>
        <pc:spChg chg="mod">
          <ac:chgData name="Héctor Cañeque Rufo" userId="6da3b7e2-2289-4c25-b14d-207ec07af19d" providerId="ADAL" clId="{110670A2-31F1-46D6-B9C0-FFC839AF2B13}" dt="2023-10-11T16:41:18.994" v="5571" actId="20577"/>
          <ac:spMkLst>
            <pc:docMk/>
            <pc:sldMk cId="3649846329" sldId="257"/>
            <ac:spMk id="22" creationId="{6A807A99-5770-26EF-83F9-A6A8D108BAE3}"/>
          </ac:spMkLst>
        </pc:spChg>
        <pc:spChg chg="del">
          <ac:chgData name="Héctor Cañeque Rufo" userId="6da3b7e2-2289-4c25-b14d-207ec07af19d" providerId="ADAL" clId="{110670A2-31F1-46D6-B9C0-FFC839AF2B13}" dt="2023-10-11T16:19:43.832" v="3619" actId="478"/>
          <ac:spMkLst>
            <pc:docMk/>
            <pc:sldMk cId="3649846329" sldId="257"/>
            <ac:spMk id="23" creationId="{61A91876-C028-5567-9581-C18C4AAD189F}"/>
          </ac:spMkLst>
        </pc:spChg>
        <pc:spChg chg="del mod">
          <ac:chgData name="Héctor Cañeque Rufo" userId="6da3b7e2-2289-4c25-b14d-207ec07af19d" providerId="ADAL" clId="{110670A2-31F1-46D6-B9C0-FFC839AF2B13}" dt="2023-10-11T16:31:41.856" v="4589" actId="478"/>
          <ac:spMkLst>
            <pc:docMk/>
            <pc:sldMk cId="3649846329" sldId="257"/>
            <ac:spMk id="42" creationId="{9C22D496-536C-F735-1800-1A2124FA07EC}"/>
          </ac:spMkLst>
        </pc:spChg>
        <pc:spChg chg="del mod">
          <ac:chgData name="Héctor Cañeque Rufo" userId="6da3b7e2-2289-4c25-b14d-207ec07af19d" providerId="ADAL" clId="{110670A2-31F1-46D6-B9C0-FFC839AF2B13}" dt="2023-10-11T16:31:57.666" v="4590" actId="478"/>
          <ac:spMkLst>
            <pc:docMk/>
            <pc:sldMk cId="3649846329" sldId="257"/>
            <ac:spMk id="43" creationId="{A5DFFFE9-F73A-351E-45F2-91C26E159BE1}"/>
          </ac:spMkLst>
        </pc:spChg>
        <pc:spChg chg="del mod">
          <ac:chgData name="Héctor Cañeque Rufo" userId="6da3b7e2-2289-4c25-b14d-207ec07af19d" providerId="ADAL" clId="{110670A2-31F1-46D6-B9C0-FFC839AF2B13}" dt="2023-10-11T16:31:35.130" v="4588" actId="478"/>
          <ac:spMkLst>
            <pc:docMk/>
            <pc:sldMk cId="3649846329" sldId="257"/>
            <ac:spMk id="46" creationId="{F50EAC61-0E79-7440-7CE9-21BA0FA12D8A}"/>
          </ac:spMkLst>
        </pc:spChg>
        <pc:spChg chg="del mod">
          <ac:chgData name="Héctor Cañeque Rufo" userId="6da3b7e2-2289-4c25-b14d-207ec07af19d" providerId="ADAL" clId="{110670A2-31F1-46D6-B9C0-FFC839AF2B13}" dt="2023-10-11T16:31:57.666" v="4590" actId="478"/>
          <ac:spMkLst>
            <pc:docMk/>
            <pc:sldMk cId="3649846329" sldId="257"/>
            <ac:spMk id="47" creationId="{44CBCBEF-F2C4-3E50-3247-26AF7F5CDC09}"/>
          </ac:spMkLst>
        </pc:spChg>
        <pc:spChg chg="mod">
          <ac:chgData name="Héctor Cañeque Rufo" userId="6da3b7e2-2289-4c25-b14d-207ec07af19d" providerId="ADAL" clId="{110670A2-31F1-46D6-B9C0-FFC839AF2B13}" dt="2023-10-11T16:31:22.229" v="4584"/>
          <ac:spMkLst>
            <pc:docMk/>
            <pc:sldMk cId="3649846329" sldId="257"/>
            <ac:spMk id="50" creationId="{247FFE84-4916-4BD1-2069-1E25172493AA}"/>
          </ac:spMkLst>
        </pc:spChg>
        <pc:spChg chg="mod">
          <ac:chgData name="Héctor Cañeque Rufo" userId="6da3b7e2-2289-4c25-b14d-207ec07af19d" providerId="ADAL" clId="{110670A2-31F1-46D6-B9C0-FFC839AF2B13}" dt="2023-10-11T16:31:22.229" v="4584"/>
          <ac:spMkLst>
            <pc:docMk/>
            <pc:sldMk cId="3649846329" sldId="257"/>
            <ac:spMk id="51" creationId="{80422DE9-82E7-F675-1FD4-D3F06CD2A7A6}"/>
          </ac:spMkLst>
        </pc:spChg>
        <pc:spChg chg="mod">
          <ac:chgData name="Héctor Cañeque Rufo" userId="6da3b7e2-2289-4c25-b14d-207ec07af19d" providerId="ADAL" clId="{110670A2-31F1-46D6-B9C0-FFC839AF2B13}" dt="2023-10-11T16:38:14.670" v="5285" actId="1035"/>
          <ac:spMkLst>
            <pc:docMk/>
            <pc:sldMk cId="3649846329" sldId="257"/>
            <ac:spMk id="56" creationId="{20E8B690-1C9E-E009-3950-1E1CA1944F63}"/>
          </ac:spMkLst>
        </pc:spChg>
        <pc:spChg chg="mod">
          <ac:chgData name="Héctor Cañeque Rufo" userId="6da3b7e2-2289-4c25-b14d-207ec07af19d" providerId="ADAL" clId="{110670A2-31F1-46D6-B9C0-FFC839AF2B13}" dt="2023-10-11T16:37:56.841" v="5192" actId="1036"/>
          <ac:spMkLst>
            <pc:docMk/>
            <pc:sldMk cId="3649846329" sldId="257"/>
            <ac:spMk id="57" creationId="{679EF4D2-599E-68CF-FF5D-3BE2DBEBE883}"/>
          </ac:spMkLst>
        </pc:spChg>
        <pc:spChg chg="mod">
          <ac:chgData name="Héctor Cañeque Rufo" userId="6da3b7e2-2289-4c25-b14d-207ec07af19d" providerId="ADAL" clId="{110670A2-31F1-46D6-B9C0-FFC839AF2B13}" dt="2023-10-11T16:37:56.841" v="5192" actId="1036"/>
          <ac:spMkLst>
            <pc:docMk/>
            <pc:sldMk cId="3649846329" sldId="257"/>
            <ac:spMk id="58" creationId="{0512CE17-2EFF-2355-1395-EE4990DBC473}"/>
          </ac:spMkLst>
        </pc:spChg>
        <pc:spChg chg="mod">
          <ac:chgData name="Héctor Cañeque Rufo" userId="6da3b7e2-2289-4c25-b14d-207ec07af19d" providerId="ADAL" clId="{110670A2-31F1-46D6-B9C0-FFC839AF2B13}" dt="2023-10-11T16:37:56.841" v="5192" actId="1036"/>
          <ac:spMkLst>
            <pc:docMk/>
            <pc:sldMk cId="3649846329" sldId="257"/>
            <ac:spMk id="59" creationId="{E0D0193C-EF3E-5F02-5523-FFECFF6A19B7}"/>
          </ac:spMkLst>
        </pc:spChg>
        <pc:spChg chg="mod">
          <ac:chgData name="Héctor Cañeque Rufo" userId="6da3b7e2-2289-4c25-b14d-207ec07af19d" providerId="ADAL" clId="{110670A2-31F1-46D6-B9C0-FFC839AF2B13}" dt="2023-10-11T16:37:56.841" v="5192" actId="1036"/>
          <ac:spMkLst>
            <pc:docMk/>
            <pc:sldMk cId="3649846329" sldId="257"/>
            <ac:spMk id="60" creationId="{3A2893AC-44BD-9042-4B38-EA241A1E9CCE}"/>
          </ac:spMkLst>
        </pc:spChg>
        <pc:spChg chg="mod">
          <ac:chgData name="Héctor Cañeque Rufo" userId="6da3b7e2-2289-4c25-b14d-207ec07af19d" providerId="ADAL" clId="{110670A2-31F1-46D6-B9C0-FFC839AF2B13}" dt="2023-10-11T16:38:28.577" v="5286" actId="1035"/>
          <ac:spMkLst>
            <pc:docMk/>
            <pc:sldMk cId="3649846329" sldId="257"/>
            <ac:spMk id="62" creationId="{29BECAA9-1E9D-ACF9-57FD-002BDD94697D}"/>
          </ac:spMkLst>
        </pc:spChg>
        <pc:spChg chg="mod">
          <ac:chgData name="Héctor Cañeque Rufo" userId="6da3b7e2-2289-4c25-b14d-207ec07af19d" providerId="ADAL" clId="{110670A2-31F1-46D6-B9C0-FFC839AF2B13}" dt="2023-10-11T16:38:28.577" v="5286" actId="1035"/>
          <ac:spMkLst>
            <pc:docMk/>
            <pc:sldMk cId="3649846329" sldId="257"/>
            <ac:spMk id="63" creationId="{06A92AE9-35AC-7233-317B-1B9E2F3AB784}"/>
          </ac:spMkLst>
        </pc:spChg>
        <pc:spChg chg="mod">
          <ac:chgData name="Héctor Cañeque Rufo" userId="6da3b7e2-2289-4c25-b14d-207ec07af19d" providerId="ADAL" clId="{110670A2-31F1-46D6-B9C0-FFC839AF2B13}" dt="2023-10-11T16:38:28.577" v="5286" actId="1035"/>
          <ac:spMkLst>
            <pc:docMk/>
            <pc:sldMk cId="3649846329" sldId="257"/>
            <ac:spMk id="64" creationId="{48E1B45B-5E0D-F294-B106-644366F37E7F}"/>
          </ac:spMkLst>
        </pc:spChg>
        <pc:spChg chg="mod">
          <ac:chgData name="Héctor Cañeque Rufo" userId="6da3b7e2-2289-4c25-b14d-207ec07af19d" providerId="ADAL" clId="{110670A2-31F1-46D6-B9C0-FFC839AF2B13}" dt="2023-10-11T16:38:28.577" v="5286" actId="1035"/>
          <ac:spMkLst>
            <pc:docMk/>
            <pc:sldMk cId="3649846329" sldId="257"/>
            <ac:spMk id="65" creationId="{186ECCDB-944C-1F7D-D260-C65D3AB99D7D}"/>
          </ac:spMkLst>
        </pc:spChg>
        <pc:spChg chg="del mod">
          <ac:chgData name="Héctor Cañeque Rufo" userId="6da3b7e2-2289-4c25-b14d-207ec07af19d" providerId="ADAL" clId="{110670A2-31F1-46D6-B9C0-FFC839AF2B13}" dt="2023-10-11T16:32:46.379" v="4594" actId="478"/>
          <ac:spMkLst>
            <pc:docMk/>
            <pc:sldMk cId="3649846329" sldId="257"/>
            <ac:spMk id="66" creationId="{9B1FBBDF-1045-5161-5165-44A1A372B8E9}"/>
          </ac:spMkLst>
        </pc:spChg>
        <pc:spChg chg="mod">
          <ac:chgData name="Héctor Cañeque Rufo" userId="6da3b7e2-2289-4c25-b14d-207ec07af19d" providerId="ADAL" clId="{110670A2-31F1-46D6-B9C0-FFC839AF2B13}" dt="2023-10-11T16:38:06.026" v="5245" actId="1035"/>
          <ac:spMkLst>
            <pc:docMk/>
            <pc:sldMk cId="3649846329" sldId="257"/>
            <ac:spMk id="67" creationId="{E78BA0F1-A4F5-B9C9-4B92-31C92C32BFA1}"/>
          </ac:spMkLst>
        </pc:spChg>
        <pc:spChg chg="del mod">
          <ac:chgData name="Héctor Cañeque Rufo" userId="6da3b7e2-2289-4c25-b14d-207ec07af19d" providerId="ADAL" clId="{110670A2-31F1-46D6-B9C0-FFC839AF2B13}" dt="2023-10-11T16:32:18.758" v="4591" actId="478"/>
          <ac:spMkLst>
            <pc:docMk/>
            <pc:sldMk cId="3649846329" sldId="257"/>
            <ac:spMk id="80" creationId="{BAC6DD0D-523C-9B69-A114-95DD710FCCF1}"/>
          </ac:spMkLst>
        </pc:spChg>
        <pc:spChg chg="del mod">
          <ac:chgData name="Héctor Cañeque Rufo" userId="6da3b7e2-2289-4c25-b14d-207ec07af19d" providerId="ADAL" clId="{110670A2-31F1-46D6-B9C0-FFC839AF2B13}" dt="2023-10-11T16:32:18.758" v="4591" actId="478"/>
          <ac:spMkLst>
            <pc:docMk/>
            <pc:sldMk cId="3649846329" sldId="257"/>
            <ac:spMk id="81" creationId="{03B64A96-616A-6BE8-8773-865DB9AAB910}"/>
          </ac:spMkLst>
        </pc:spChg>
        <pc:spChg chg="del mod">
          <ac:chgData name="Héctor Cañeque Rufo" userId="6da3b7e2-2289-4c25-b14d-207ec07af19d" providerId="ADAL" clId="{110670A2-31F1-46D6-B9C0-FFC839AF2B13}" dt="2023-10-11T16:32:23.728" v="4592" actId="478"/>
          <ac:spMkLst>
            <pc:docMk/>
            <pc:sldMk cId="3649846329" sldId="257"/>
            <ac:spMk id="82" creationId="{F402A129-2B4F-0648-02B0-E8C062F5DD1A}"/>
          </ac:spMkLst>
        </pc:spChg>
        <pc:spChg chg="del mod">
          <ac:chgData name="Héctor Cañeque Rufo" userId="6da3b7e2-2289-4c25-b14d-207ec07af19d" providerId="ADAL" clId="{110670A2-31F1-46D6-B9C0-FFC839AF2B13}" dt="2023-10-11T16:32:18.758" v="4591" actId="478"/>
          <ac:spMkLst>
            <pc:docMk/>
            <pc:sldMk cId="3649846329" sldId="257"/>
            <ac:spMk id="83" creationId="{93A52FC3-4310-136F-3572-C6EAAA4C6EAA}"/>
          </ac:spMkLst>
        </pc:spChg>
        <pc:spChg chg="del mod">
          <ac:chgData name="Héctor Cañeque Rufo" userId="6da3b7e2-2289-4c25-b14d-207ec07af19d" providerId="ADAL" clId="{110670A2-31F1-46D6-B9C0-FFC839AF2B13}" dt="2023-10-11T16:32:18.758" v="4591" actId="478"/>
          <ac:spMkLst>
            <pc:docMk/>
            <pc:sldMk cId="3649846329" sldId="257"/>
            <ac:spMk id="84" creationId="{5E8DEBB8-4B9E-5AF7-A90F-4D30E4588D82}"/>
          </ac:spMkLst>
        </pc:spChg>
        <pc:spChg chg="del mod">
          <ac:chgData name="Héctor Cañeque Rufo" userId="6da3b7e2-2289-4c25-b14d-207ec07af19d" providerId="ADAL" clId="{110670A2-31F1-46D6-B9C0-FFC839AF2B13}" dt="2023-10-11T16:32:18.758" v="4591" actId="478"/>
          <ac:spMkLst>
            <pc:docMk/>
            <pc:sldMk cId="3649846329" sldId="257"/>
            <ac:spMk id="85" creationId="{DFB10E33-1547-54FF-55B0-B373E428847E}"/>
          </ac:spMkLst>
        </pc:spChg>
        <pc:spChg chg="del mod">
          <ac:chgData name="Héctor Cañeque Rufo" userId="6da3b7e2-2289-4c25-b14d-207ec07af19d" providerId="ADAL" clId="{110670A2-31F1-46D6-B9C0-FFC839AF2B13}" dt="2023-10-11T16:32:18.758" v="4591" actId="478"/>
          <ac:spMkLst>
            <pc:docMk/>
            <pc:sldMk cId="3649846329" sldId="257"/>
            <ac:spMk id="86" creationId="{65B2E47C-708B-0DC8-D02F-4AAB5E69B67E}"/>
          </ac:spMkLst>
        </pc:spChg>
        <pc:spChg chg="del mod">
          <ac:chgData name="Héctor Cañeque Rufo" userId="6da3b7e2-2289-4c25-b14d-207ec07af19d" providerId="ADAL" clId="{110670A2-31F1-46D6-B9C0-FFC839AF2B13}" dt="2023-10-11T16:33:00.015" v="4595" actId="478"/>
          <ac:spMkLst>
            <pc:docMk/>
            <pc:sldMk cId="3649846329" sldId="257"/>
            <ac:spMk id="99" creationId="{6940DA54-AE09-75AB-C468-761636E32F3C}"/>
          </ac:spMkLst>
        </pc:spChg>
        <pc:spChg chg="del mod">
          <ac:chgData name="Héctor Cañeque Rufo" userId="6da3b7e2-2289-4c25-b14d-207ec07af19d" providerId="ADAL" clId="{110670A2-31F1-46D6-B9C0-FFC839AF2B13}" dt="2023-10-11T16:32:46.379" v="4594" actId="478"/>
          <ac:spMkLst>
            <pc:docMk/>
            <pc:sldMk cId="3649846329" sldId="257"/>
            <ac:spMk id="100" creationId="{BC014F6D-D7DB-A879-5F96-4BA8C2FDF170}"/>
          </ac:spMkLst>
        </pc:spChg>
        <pc:spChg chg="del mod">
          <ac:chgData name="Héctor Cañeque Rufo" userId="6da3b7e2-2289-4c25-b14d-207ec07af19d" providerId="ADAL" clId="{110670A2-31F1-46D6-B9C0-FFC839AF2B13}" dt="2023-10-11T16:33:00.015" v="4595" actId="478"/>
          <ac:spMkLst>
            <pc:docMk/>
            <pc:sldMk cId="3649846329" sldId="257"/>
            <ac:spMk id="101" creationId="{1473BAB8-EB6A-97C8-F358-37F3FF07DB6E}"/>
          </ac:spMkLst>
        </pc:spChg>
        <pc:spChg chg="del mod">
          <ac:chgData name="Héctor Cañeque Rufo" userId="6da3b7e2-2289-4c25-b14d-207ec07af19d" providerId="ADAL" clId="{110670A2-31F1-46D6-B9C0-FFC839AF2B13}" dt="2023-10-11T16:33:00.015" v="4595" actId="478"/>
          <ac:spMkLst>
            <pc:docMk/>
            <pc:sldMk cId="3649846329" sldId="257"/>
            <ac:spMk id="102" creationId="{825C1E27-DFE4-FFE1-ADEE-60FF0A892EF8}"/>
          </ac:spMkLst>
        </pc:spChg>
        <pc:spChg chg="del mod">
          <ac:chgData name="Héctor Cañeque Rufo" userId="6da3b7e2-2289-4c25-b14d-207ec07af19d" providerId="ADAL" clId="{110670A2-31F1-46D6-B9C0-FFC839AF2B13}" dt="2023-10-11T16:33:00.015" v="4595" actId="478"/>
          <ac:spMkLst>
            <pc:docMk/>
            <pc:sldMk cId="3649846329" sldId="257"/>
            <ac:spMk id="103" creationId="{726B1FBD-1EDA-22F2-6AA0-67E968634268}"/>
          </ac:spMkLst>
        </pc:spChg>
        <pc:spChg chg="del mod">
          <ac:chgData name="Héctor Cañeque Rufo" userId="6da3b7e2-2289-4c25-b14d-207ec07af19d" providerId="ADAL" clId="{110670A2-31F1-46D6-B9C0-FFC839AF2B13}" dt="2023-10-11T16:33:00.015" v="4595" actId="478"/>
          <ac:spMkLst>
            <pc:docMk/>
            <pc:sldMk cId="3649846329" sldId="257"/>
            <ac:spMk id="104" creationId="{C7284A1E-1643-4648-AD27-C929794FABC7}"/>
          </ac:spMkLst>
        </pc:spChg>
        <pc:spChg chg="del mod">
          <ac:chgData name="Héctor Cañeque Rufo" userId="6da3b7e2-2289-4c25-b14d-207ec07af19d" providerId="ADAL" clId="{110670A2-31F1-46D6-B9C0-FFC839AF2B13}" dt="2023-10-11T16:33:00.015" v="4595" actId="478"/>
          <ac:spMkLst>
            <pc:docMk/>
            <pc:sldMk cId="3649846329" sldId="257"/>
            <ac:spMk id="105" creationId="{5F4A2C2A-23B2-856D-D881-7E10D358F83F}"/>
          </ac:spMkLst>
        </pc:spChg>
        <pc:spChg chg="mod ord">
          <ac:chgData name="Héctor Cañeque Rufo" userId="6da3b7e2-2289-4c25-b14d-207ec07af19d" providerId="ADAL" clId="{110670A2-31F1-46D6-B9C0-FFC839AF2B13}" dt="2023-10-11T16:36:15.667" v="4991" actId="167"/>
          <ac:spMkLst>
            <pc:docMk/>
            <pc:sldMk cId="3649846329" sldId="257"/>
            <ac:spMk id="118" creationId="{0B0D73B8-5DB8-F6B6-5CF1-74DCA204ECC4}"/>
          </ac:spMkLst>
        </pc:spChg>
        <pc:spChg chg="mod ord">
          <ac:chgData name="Héctor Cañeque Rufo" userId="6da3b7e2-2289-4c25-b14d-207ec07af19d" providerId="ADAL" clId="{110670A2-31F1-46D6-B9C0-FFC839AF2B13}" dt="2023-10-11T16:36:15.667" v="4991" actId="167"/>
          <ac:spMkLst>
            <pc:docMk/>
            <pc:sldMk cId="3649846329" sldId="257"/>
            <ac:spMk id="119" creationId="{62E82A19-5DC4-2AC5-FC81-77928530E51A}"/>
          </ac:spMkLst>
        </pc:spChg>
        <pc:spChg chg="mod ord">
          <ac:chgData name="Héctor Cañeque Rufo" userId="6da3b7e2-2289-4c25-b14d-207ec07af19d" providerId="ADAL" clId="{110670A2-31F1-46D6-B9C0-FFC839AF2B13}" dt="2023-10-11T16:36:15.667" v="4991" actId="167"/>
          <ac:spMkLst>
            <pc:docMk/>
            <pc:sldMk cId="3649846329" sldId="257"/>
            <ac:spMk id="120" creationId="{27D2E037-F0F2-EF1D-C01B-750924E4165A}"/>
          </ac:spMkLst>
        </pc:spChg>
        <pc:spChg chg="mod ord">
          <ac:chgData name="Héctor Cañeque Rufo" userId="6da3b7e2-2289-4c25-b14d-207ec07af19d" providerId="ADAL" clId="{110670A2-31F1-46D6-B9C0-FFC839AF2B13}" dt="2023-10-11T16:36:15.667" v="4991" actId="167"/>
          <ac:spMkLst>
            <pc:docMk/>
            <pc:sldMk cId="3649846329" sldId="257"/>
            <ac:spMk id="121" creationId="{87F25657-AC3A-5D6D-EACD-3FCD8D0D8863}"/>
          </ac:spMkLst>
        </pc:spChg>
        <pc:spChg chg="mod ord">
          <ac:chgData name="Héctor Cañeque Rufo" userId="6da3b7e2-2289-4c25-b14d-207ec07af19d" providerId="ADAL" clId="{110670A2-31F1-46D6-B9C0-FFC839AF2B13}" dt="2023-10-11T16:36:15.667" v="4991" actId="167"/>
          <ac:spMkLst>
            <pc:docMk/>
            <pc:sldMk cId="3649846329" sldId="257"/>
            <ac:spMk id="122" creationId="{04F6796B-9BCD-8ED1-7647-67ED34EE9B76}"/>
          </ac:spMkLst>
        </pc:spChg>
        <pc:spChg chg="mod ord">
          <ac:chgData name="Héctor Cañeque Rufo" userId="6da3b7e2-2289-4c25-b14d-207ec07af19d" providerId="ADAL" clId="{110670A2-31F1-46D6-B9C0-FFC839AF2B13}" dt="2023-10-11T16:36:15.667" v="4991" actId="167"/>
          <ac:spMkLst>
            <pc:docMk/>
            <pc:sldMk cId="3649846329" sldId="257"/>
            <ac:spMk id="123" creationId="{C73D2C36-02EC-10A8-2DCB-F6285D5ADA5F}"/>
          </ac:spMkLst>
        </pc:spChg>
        <pc:spChg chg="mod ord">
          <ac:chgData name="Héctor Cañeque Rufo" userId="6da3b7e2-2289-4c25-b14d-207ec07af19d" providerId="ADAL" clId="{110670A2-31F1-46D6-B9C0-FFC839AF2B13}" dt="2023-10-11T16:36:15.667" v="4991" actId="167"/>
          <ac:spMkLst>
            <pc:docMk/>
            <pc:sldMk cId="3649846329" sldId="257"/>
            <ac:spMk id="124" creationId="{9BE9F6B5-CAC8-4C43-8373-3C88D718F5DA}"/>
          </ac:spMkLst>
        </pc:spChg>
        <pc:spChg chg="add del mod">
          <ac:chgData name="Héctor Cañeque Rufo" userId="6da3b7e2-2289-4c25-b14d-207ec07af19d" providerId="ADAL" clId="{110670A2-31F1-46D6-B9C0-FFC839AF2B13}" dt="2023-10-11T16:40:58.274" v="5527" actId="478"/>
          <ac:spMkLst>
            <pc:docMk/>
            <pc:sldMk cId="3649846329" sldId="257"/>
            <ac:spMk id="125" creationId="{4899BEB7-E416-E9B0-5399-4C079ADF599D}"/>
          </ac:spMkLst>
        </pc:spChg>
        <pc:spChg chg="add mod">
          <ac:chgData name="Héctor Cañeque Rufo" userId="6da3b7e2-2289-4c25-b14d-207ec07af19d" providerId="ADAL" clId="{110670A2-31F1-46D6-B9C0-FFC839AF2B13}" dt="2023-10-11T16:41:45.324" v="5576" actId="164"/>
          <ac:spMkLst>
            <pc:docMk/>
            <pc:sldMk cId="3649846329" sldId="257"/>
            <ac:spMk id="127" creationId="{0215AD33-6AF5-C805-CD40-68BF691BFFA0}"/>
          </ac:spMkLst>
        </pc:spChg>
        <pc:grpChg chg="add mod">
          <ac:chgData name="Héctor Cañeque Rufo" userId="6da3b7e2-2289-4c25-b14d-207ec07af19d" providerId="ADAL" clId="{110670A2-31F1-46D6-B9C0-FFC839AF2B13}" dt="2023-10-11T16:41:45.324" v="5576" actId="164"/>
          <ac:grpSpMkLst>
            <pc:docMk/>
            <pc:sldMk cId="3649846329" sldId="257"/>
            <ac:grpSpMk id="8" creationId="{14A77C6F-1CB5-006C-BAD9-D009FBEAB367}"/>
          </ac:grpSpMkLst>
        </pc:grpChg>
        <pc:grpChg chg="add del mod">
          <ac:chgData name="Héctor Cañeque Rufo" userId="6da3b7e2-2289-4c25-b14d-207ec07af19d" providerId="ADAL" clId="{110670A2-31F1-46D6-B9C0-FFC839AF2B13}" dt="2023-10-11T16:39:35.403" v="5488" actId="21"/>
          <ac:grpSpMkLst>
            <pc:docMk/>
            <pc:sldMk cId="3649846329" sldId="257"/>
            <ac:grpSpMk id="10" creationId="{B60C4847-6E80-6357-574D-49BEC19166F7}"/>
          </ac:grpSpMkLst>
        </pc:grpChg>
        <pc:grpChg chg="mod">
          <ac:chgData name="Héctor Cañeque Rufo" userId="6da3b7e2-2289-4c25-b14d-207ec07af19d" providerId="ADAL" clId="{110670A2-31F1-46D6-B9C0-FFC839AF2B13}" dt="2023-10-11T16:31:22.229" v="4584"/>
          <ac:grpSpMkLst>
            <pc:docMk/>
            <pc:sldMk cId="3649846329" sldId="257"/>
            <ac:grpSpMk id="11" creationId="{0ABD2884-FAD2-917F-E8F5-7BFE86CF1E29}"/>
          </ac:grpSpMkLst>
        </pc:grpChg>
        <pc:grpChg chg="mod">
          <ac:chgData name="Héctor Cañeque Rufo" userId="6da3b7e2-2289-4c25-b14d-207ec07af19d" providerId="ADAL" clId="{110670A2-31F1-46D6-B9C0-FFC839AF2B13}" dt="2023-10-11T16:31:22.229" v="4584"/>
          <ac:grpSpMkLst>
            <pc:docMk/>
            <pc:sldMk cId="3649846329" sldId="257"/>
            <ac:grpSpMk id="20" creationId="{C20D6CAA-CD11-CDEA-FB19-9DDF5FC93A8E}"/>
          </ac:grpSpMkLst>
        </pc:grpChg>
        <pc:grpChg chg="mod">
          <ac:chgData name="Héctor Cañeque Rufo" userId="6da3b7e2-2289-4c25-b14d-207ec07af19d" providerId="ADAL" clId="{110670A2-31F1-46D6-B9C0-FFC839AF2B13}" dt="2023-10-11T16:31:22.229" v="4584"/>
          <ac:grpSpMkLst>
            <pc:docMk/>
            <pc:sldMk cId="3649846329" sldId="257"/>
            <ac:grpSpMk id="38" creationId="{F12DB583-13F8-BB58-8730-612DE61B220A}"/>
          </ac:grpSpMkLst>
        </pc:grpChg>
        <pc:grpChg chg="mod">
          <ac:chgData name="Héctor Cañeque Rufo" userId="6da3b7e2-2289-4c25-b14d-207ec07af19d" providerId="ADAL" clId="{110670A2-31F1-46D6-B9C0-FFC839AF2B13}" dt="2023-10-11T16:31:22.229" v="4584"/>
          <ac:grpSpMkLst>
            <pc:docMk/>
            <pc:sldMk cId="3649846329" sldId="257"/>
            <ac:grpSpMk id="39" creationId="{1DE91870-625B-438D-1A0C-E5E3B72F4B89}"/>
          </ac:grpSpMkLst>
        </pc:grpChg>
        <pc:grpChg chg="del mod">
          <ac:chgData name="Héctor Cañeque Rufo" userId="6da3b7e2-2289-4c25-b14d-207ec07af19d" providerId="ADAL" clId="{110670A2-31F1-46D6-B9C0-FFC839AF2B13}" dt="2023-10-11T16:31:41.856" v="4589" actId="478"/>
          <ac:grpSpMkLst>
            <pc:docMk/>
            <pc:sldMk cId="3649846329" sldId="257"/>
            <ac:grpSpMk id="40" creationId="{EA500228-15B1-C1E6-8CBF-DCE4AFCB0A1D}"/>
          </ac:grpSpMkLst>
        </pc:grpChg>
        <pc:grpChg chg="del mod">
          <ac:chgData name="Héctor Cañeque Rufo" userId="6da3b7e2-2289-4c25-b14d-207ec07af19d" providerId="ADAL" clId="{110670A2-31F1-46D6-B9C0-FFC839AF2B13}" dt="2023-10-11T16:31:57.666" v="4590" actId="478"/>
          <ac:grpSpMkLst>
            <pc:docMk/>
            <pc:sldMk cId="3649846329" sldId="257"/>
            <ac:grpSpMk id="41" creationId="{6EA992D2-BB43-7EEE-55AA-48AD0ABB884F}"/>
          </ac:grpSpMkLst>
        </pc:grpChg>
        <pc:grpChg chg="mod">
          <ac:chgData name="Héctor Cañeque Rufo" userId="6da3b7e2-2289-4c25-b14d-207ec07af19d" providerId="ADAL" clId="{110670A2-31F1-46D6-B9C0-FFC839AF2B13}" dt="2023-10-11T16:31:22.229" v="4584"/>
          <ac:grpSpMkLst>
            <pc:docMk/>
            <pc:sldMk cId="3649846329" sldId="257"/>
            <ac:grpSpMk id="54" creationId="{06D38ABE-EF20-2780-7A5E-82503B50588D}"/>
          </ac:grpSpMkLst>
        </pc:grpChg>
        <pc:grpChg chg="del mod">
          <ac:chgData name="Héctor Cañeque Rufo" userId="6da3b7e2-2289-4c25-b14d-207ec07af19d" providerId="ADAL" clId="{110670A2-31F1-46D6-B9C0-FFC839AF2B13}" dt="2023-10-11T16:33:00.015" v="4595" actId="478"/>
          <ac:grpSpMkLst>
            <pc:docMk/>
            <pc:sldMk cId="3649846329" sldId="257"/>
            <ac:grpSpMk id="55" creationId="{81B276E5-C276-8DF1-E742-FBDBA1E386EB}"/>
          </ac:grpSpMkLst>
        </pc:grpChg>
        <pc:grpChg chg="del mod">
          <ac:chgData name="Héctor Cañeque Rufo" userId="6da3b7e2-2289-4c25-b14d-207ec07af19d" providerId="ADAL" clId="{110670A2-31F1-46D6-B9C0-FFC839AF2B13}" dt="2023-10-11T16:32:38.723" v="4593" actId="478"/>
          <ac:grpSpMkLst>
            <pc:docMk/>
            <pc:sldMk cId="3649846329" sldId="257"/>
            <ac:grpSpMk id="61" creationId="{6B0E6002-805D-1ED9-1160-3A259295AD89}"/>
          </ac:grpSpMkLst>
        </pc:grpChg>
        <pc:grpChg chg="add mod">
          <ac:chgData name="Héctor Cañeque Rufo" userId="6da3b7e2-2289-4c25-b14d-207ec07af19d" providerId="ADAL" clId="{110670A2-31F1-46D6-B9C0-FFC839AF2B13}" dt="2023-10-11T16:41:55.550" v="5648" actId="1037"/>
          <ac:grpSpMkLst>
            <pc:docMk/>
            <pc:sldMk cId="3649846329" sldId="257"/>
            <ac:grpSpMk id="128" creationId="{30C19935-BF34-7BBB-2A21-239F2F8664AE}"/>
          </ac:grpSpMkLst>
        </pc:grpChg>
        <pc:picChg chg="mod">
          <ac:chgData name="Héctor Cañeque Rufo" userId="6da3b7e2-2289-4c25-b14d-207ec07af19d" providerId="ADAL" clId="{110670A2-31F1-46D6-B9C0-FFC839AF2B13}" dt="2023-10-11T16:25:16.692" v="4471" actId="164"/>
          <ac:picMkLst>
            <pc:docMk/>
            <pc:sldMk cId="3649846329" sldId="257"/>
            <ac:picMk id="6" creationId="{C47E6BA4-4479-B515-6C61-9218E35EA25F}"/>
          </ac:picMkLst>
        </pc:picChg>
        <pc:picChg chg="del">
          <ac:chgData name="Héctor Cañeque Rufo" userId="6da3b7e2-2289-4c25-b14d-207ec07af19d" providerId="ADAL" clId="{110670A2-31F1-46D6-B9C0-FFC839AF2B13}" dt="2023-10-11T16:19:45.496" v="3620" actId="478"/>
          <ac:picMkLst>
            <pc:docMk/>
            <pc:sldMk cId="3649846329" sldId="257"/>
            <ac:picMk id="7" creationId="{265DDCD2-73FD-FCC3-6978-A9DF6E8F5A43}"/>
          </ac:picMkLst>
        </pc:picChg>
        <pc:picChg chg="add del mod">
          <ac:chgData name="Héctor Cañeque Rufo" userId="6da3b7e2-2289-4c25-b14d-207ec07af19d" providerId="ADAL" clId="{110670A2-31F1-46D6-B9C0-FFC839AF2B13}" dt="2023-10-11T16:39:30.193" v="5486" actId="478"/>
          <ac:picMkLst>
            <pc:docMk/>
            <pc:sldMk cId="3649846329" sldId="257"/>
            <ac:picMk id="9" creationId="{9E83E5BD-8378-97D0-0405-027AFFD664AE}"/>
          </ac:picMkLst>
        </pc:picChg>
        <pc:picChg chg="mod">
          <ac:chgData name="Héctor Cañeque Rufo" userId="6da3b7e2-2289-4c25-b14d-207ec07af19d" providerId="ADAL" clId="{110670A2-31F1-46D6-B9C0-FFC839AF2B13}" dt="2023-10-11T16:42:54.726" v="5655" actId="1036"/>
          <ac:picMkLst>
            <pc:docMk/>
            <pc:sldMk cId="3649846329" sldId="257"/>
            <ac:picMk id="12" creationId="{9C80E917-8625-BD51-DB49-917151A4F2D2}"/>
          </ac:picMkLst>
        </pc:picChg>
        <pc:picChg chg="mod">
          <ac:chgData name="Héctor Cañeque Rufo" userId="6da3b7e2-2289-4c25-b14d-207ec07af19d" providerId="ADAL" clId="{110670A2-31F1-46D6-B9C0-FFC839AF2B13}" dt="2023-10-13T06:51:06.108" v="5666" actId="1035"/>
          <ac:picMkLst>
            <pc:docMk/>
            <pc:sldMk cId="3649846329" sldId="257"/>
            <ac:picMk id="13" creationId="{7A3A51E2-91FA-7E94-C135-E09B6717C731}"/>
          </ac:picMkLst>
        </pc:picChg>
        <pc:picChg chg="mod">
          <ac:chgData name="Héctor Cañeque Rufo" userId="6da3b7e2-2289-4c25-b14d-207ec07af19d" providerId="ADAL" clId="{110670A2-31F1-46D6-B9C0-FFC839AF2B13}" dt="2023-10-11T16:42:54.726" v="5655" actId="1036"/>
          <ac:picMkLst>
            <pc:docMk/>
            <pc:sldMk cId="3649846329" sldId="257"/>
            <ac:picMk id="18" creationId="{DA55C7F4-6D6B-A553-D147-77A365D4BCF8}"/>
          </ac:picMkLst>
        </pc:picChg>
        <pc:picChg chg="mod">
          <ac:chgData name="Héctor Cañeque Rufo" userId="6da3b7e2-2289-4c25-b14d-207ec07af19d" providerId="ADAL" clId="{110670A2-31F1-46D6-B9C0-FFC839AF2B13}" dt="2023-10-13T06:51:06.108" v="5666" actId="1035"/>
          <ac:picMkLst>
            <pc:docMk/>
            <pc:sldMk cId="3649846329" sldId="257"/>
            <ac:picMk id="19" creationId="{9724040B-0196-9AD6-E635-0094BB96A211}"/>
          </ac:picMkLst>
        </pc:picChg>
        <pc:picChg chg="del">
          <ac:chgData name="Héctor Cañeque Rufo" userId="6da3b7e2-2289-4c25-b14d-207ec07af19d" providerId="ADAL" clId="{110670A2-31F1-46D6-B9C0-FFC839AF2B13}" dt="2023-10-11T16:19:38.763" v="3617" actId="478"/>
          <ac:picMkLst>
            <pc:docMk/>
            <pc:sldMk cId="3649846329" sldId="257"/>
            <ac:picMk id="24" creationId="{14033417-772B-A47C-5E24-843A3841337A}"/>
          </ac:picMkLst>
        </pc:picChg>
        <pc:picChg chg="del">
          <ac:chgData name="Héctor Cañeque Rufo" userId="6da3b7e2-2289-4c25-b14d-207ec07af19d" providerId="ADAL" clId="{110670A2-31F1-46D6-B9C0-FFC839AF2B13}" dt="2023-10-11T16:19:41.004" v="3618" actId="478"/>
          <ac:picMkLst>
            <pc:docMk/>
            <pc:sldMk cId="3649846329" sldId="257"/>
            <ac:picMk id="26" creationId="{F01FA171-A34E-7474-ED42-645951E30860}"/>
          </ac:picMkLst>
        </pc:picChg>
        <pc:picChg chg="del mod">
          <ac:chgData name="Héctor Cañeque Rufo" userId="6da3b7e2-2289-4c25-b14d-207ec07af19d" providerId="ADAL" clId="{110670A2-31F1-46D6-B9C0-FFC839AF2B13}" dt="2023-10-11T16:31:41.856" v="4589" actId="478"/>
          <ac:picMkLst>
            <pc:docMk/>
            <pc:sldMk cId="3649846329" sldId="257"/>
            <ac:picMk id="44" creationId="{552422B1-8326-7E36-56EB-E531830A7880}"/>
          </ac:picMkLst>
        </pc:picChg>
        <pc:picChg chg="del mod">
          <ac:chgData name="Héctor Cañeque Rufo" userId="6da3b7e2-2289-4c25-b14d-207ec07af19d" providerId="ADAL" clId="{110670A2-31F1-46D6-B9C0-FFC839AF2B13}" dt="2023-10-11T16:31:57.666" v="4590" actId="478"/>
          <ac:picMkLst>
            <pc:docMk/>
            <pc:sldMk cId="3649846329" sldId="257"/>
            <ac:picMk id="45" creationId="{6CE0761A-C899-91FA-3FE0-703049697D80}"/>
          </ac:picMkLst>
        </pc:picChg>
        <pc:picChg chg="del mod">
          <ac:chgData name="Héctor Cañeque Rufo" userId="6da3b7e2-2289-4c25-b14d-207ec07af19d" providerId="ADAL" clId="{110670A2-31F1-46D6-B9C0-FFC839AF2B13}" dt="2023-10-11T16:31:41.856" v="4589" actId="478"/>
          <ac:picMkLst>
            <pc:docMk/>
            <pc:sldMk cId="3649846329" sldId="257"/>
            <ac:picMk id="48" creationId="{1F93C458-7A7A-88A9-DED0-0A16F8105ECE}"/>
          </ac:picMkLst>
        </pc:picChg>
        <pc:picChg chg="del mod">
          <ac:chgData name="Héctor Cañeque Rufo" userId="6da3b7e2-2289-4c25-b14d-207ec07af19d" providerId="ADAL" clId="{110670A2-31F1-46D6-B9C0-FFC839AF2B13}" dt="2023-10-11T16:31:41.856" v="4589" actId="478"/>
          <ac:picMkLst>
            <pc:docMk/>
            <pc:sldMk cId="3649846329" sldId="257"/>
            <ac:picMk id="49" creationId="{ABF07E50-F63E-7F41-64FE-16F4B81A7CB0}"/>
          </ac:picMkLst>
        </pc:picChg>
        <pc:picChg chg="mod">
          <ac:chgData name="Héctor Cañeque Rufo" userId="6da3b7e2-2289-4c25-b14d-207ec07af19d" providerId="ADAL" clId="{110670A2-31F1-46D6-B9C0-FFC839AF2B13}" dt="2023-10-11T16:31:22.229" v="4584"/>
          <ac:picMkLst>
            <pc:docMk/>
            <pc:sldMk cId="3649846329" sldId="257"/>
            <ac:picMk id="52" creationId="{3F0E339A-1A9C-0C52-75E0-797AE7834064}"/>
          </ac:picMkLst>
        </pc:picChg>
        <pc:picChg chg="mod">
          <ac:chgData name="Héctor Cañeque Rufo" userId="6da3b7e2-2289-4c25-b14d-207ec07af19d" providerId="ADAL" clId="{110670A2-31F1-46D6-B9C0-FFC839AF2B13}" dt="2023-10-11T16:31:22.229" v="4584"/>
          <ac:picMkLst>
            <pc:docMk/>
            <pc:sldMk cId="3649846329" sldId="257"/>
            <ac:picMk id="53" creationId="{96ABD140-D08E-1D5D-F5EE-1A33231AF686}"/>
          </ac:picMkLst>
        </pc:picChg>
        <pc:picChg chg="add mod">
          <ac:chgData name="Héctor Cañeque Rufo" userId="6da3b7e2-2289-4c25-b14d-207ec07af19d" providerId="ADAL" clId="{110670A2-31F1-46D6-B9C0-FFC839AF2B13}" dt="2023-10-11T16:41:45.324" v="5576" actId="164"/>
          <ac:picMkLst>
            <pc:docMk/>
            <pc:sldMk cId="3649846329" sldId="257"/>
            <ac:picMk id="126" creationId="{B96D4EE1-7E6A-97AD-B784-B09181F7E8F7}"/>
          </ac:picMkLst>
        </pc:picChg>
        <pc:cxnChg chg="mod">
          <ac:chgData name="Héctor Cañeque Rufo" userId="6da3b7e2-2289-4c25-b14d-207ec07af19d" providerId="ADAL" clId="{110670A2-31F1-46D6-B9C0-FFC839AF2B13}" dt="2023-10-11T16:37:56.841" v="5192" actId="1036"/>
          <ac:cxnSpMkLst>
            <pc:docMk/>
            <pc:sldMk cId="3649846329" sldId="257"/>
            <ac:cxnSpMk id="25" creationId="{91DB484B-A78E-70BB-771D-90E450680697}"/>
          </ac:cxnSpMkLst>
        </pc:cxnChg>
        <pc:cxnChg chg="mod">
          <ac:chgData name="Héctor Cañeque Rufo" userId="6da3b7e2-2289-4c25-b14d-207ec07af19d" providerId="ADAL" clId="{110670A2-31F1-46D6-B9C0-FFC839AF2B13}" dt="2023-10-11T16:37:56.841" v="5192" actId="1036"/>
          <ac:cxnSpMkLst>
            <pc:docMk/>
            <pc:sldMk cId="3649846329" sldId="257"/>
            <ac:cxnSpMk id="27" creationId="{A160C448-6549-E267-3D50-A488FDEBE748}"/>
          </ac:cxnSpMkLst>
        </pc:cxnChg>
        <pc:cxnChg chg="mod">
          <ac:chgData name="Héctor Cañeque Rufo" userId="6da3b7e2-2289-4c25-b14d-207ec07af19d" providerId="ADAL" clId="{110670A2-31F1-46D6-B9C0-FFC839AF2B13}" dt="2023-10-11T16:37:56.841" v="5192" actId="1036"/>
          <ac:cxnSpMkLst>
            <pc:docMk/>
            <pc:sldMk cId="3649846329" sldId="257"/>
            <ac:cxnSpMk id="28" creationId="{F71297BB-6D4F-8D5F-B4FB-30F3DE46C544}"/>
          </ac:cxnSpMkLst>
        </pc:cxnChg>
        <pc:cxnChg chg="mod">
          <ac:chgData name="Héctor Cañeque Rufo" userId="6da3b7e2-2289-4c25-b14d-207ec07af19d" providerId="ADAL" clId="{110670A2-31F1-46D6-B9C0-FFC839AF2B13}" dt="2023-10-11T16:37:56.841" v="5192" actId="1036"/>
          <ac:cxnSpMkLst>
            <pc:docMk/>
            <pc:sldMk cId="3649846329" sldId="257"/>
            <ac:cxnSpMk id="29" creationId="{EA12E3B8-971C-5103-390B-F68BC821DC44}"/>
          </ac:cxnSpMkLst>
        </pc:cxnChg>
        <pc:cxnChg chg="add del mod">
          <ac:chgData name="Héctor Cañeque Rufo" userId="6da3b7e2-2289-4c25-b14d-207ec07af19d" providerId="ADAL" clId="{110670A2-31F1-46D6-B9C0-FFC839AF2B13}" dt="2023-10-11T16:36:40.188" v="5010" actId="478"/>
          <ac:cxnSpMkLst>
            <pc:docMk/>
            <pc:sldMk cId="3649846329" sldId="257"/>
            <ac:cxnSpMk id="30" creationId="{9E3ED488-8EBF-FB24-6C69-400ABEA0BE14}"/>
          </ac:cxnSpMkLst>
        </pc:cxnChg>
        <pc:cxnChg chg="add del mod">
          <ac:chgData name="Héctor Cañeque Rufo" userId="6da3b7e2-2289-4c25-b14d-207ec07af19d" providerId="ADAL" clId="{110670A2-31F1-46D6-B9C0-FFC839AF2B13}" dt="2023-10-11T16:36:40.188" v="5010" actId="478"/>
          <ac:cxnSpMkLst>
            <pc:docMk/>
            <pc:sldMk cId="3649846329" sldId="257"/>
            <ac:cxnSpMk id="31" creationId="{75AC6A6B-E6F9-4ED3-7C50-230A2EC62F3F}"/>
          </ac:cxnSpMkLst>
        </pc:cxnChg>
        <pc:cxnChg chg="add del mod">
          <ac:chgData name="Héctor Cañeque Rufo" userId="6da3b7e2-2289-4c25-b14d-207ec07af19d" providerId="ADAL" clId="{110670A2-31F1-46D6-B9C0-FFC839AF2B13}" dt="2023-10-11T16:36:40.188" v="5010" actId="478"/>
          <ac:cxnSpMkLst>
            <pc:docMk/>
            <pc:sldMk cId="3649846329" sldId="257"/>
            <ac:cxnSpMk id="32" creationId="{A707D6DA-632E-8863-E6B9-BBCBD43FAD81}"/>
          </ac:cxnSpMkLst>
        </pc:cxnChg>
        <pc:cxnChg chg="add del mod">
          <ac:chgData name="Héctor Cañeque Rufo" userId="6da3b7e2-2289-4c25-b14d-207ec07af19d" providerId="ADAL" clId="{110670A2-31F1-46D6-B9C0-FFC839AF2B13}" dt="2023-10-11T16:36:40.188" v="5010" actId="478"/>
          <ac:cxnSpMkLst>
            <pc:docMk/>
            <pc:sldMk cId="3649846329" sldId="257"/>
            <ac:cxnSpMk id="33" creationId="{FC9703C6-36EC-B3E0-3BF8-355036583D20}"/>
          </ac:cxnSpMkLst>
        </pc:cxnChg>
        <pc:cxnChg chg="del mod">
          <ac:chgData name="Héctor Cañeque Rufo" userId="6da3b7e2-2289-4c25-b14d-207ec07af19d" providerId="ADAL" clId="{110670A2-31F1-46D6-B9C0-FFC839AF2B13}" dt="2023-10-11T16:32:38.723" v="4593" actId="478"/>
          <ac:cxnSpMkLst>
            <pc:docMk/>
            <pc:sldMk cId="3649846329" sldId="257"/>
            <ac:cxnSpMk id="34" creationId="{4DDBD4CF-EA0F-C1FA-7AD0-6CA55B55DDBC}"/>
          </ac:cxnSpMkLst>
        </pc:cxnChg>
        <pc:cxnChg chg="del mod">
          <ac:chgData name="Héctor Cañeque Rufo" userId="6da3b7e2-2289-4c25-b14d-207ec07af19d" providerId="ADAL" clId="{110670A2-31F1-46D6-B9C0-FFC839AF2B13}" dt="2023-10-11T16:32:38.723" v="4593" actId="478"/>
          <ac:cxnSpMkLst>
            <pc:docMk/>
            <pc:sldMk cId="3649846329" sldId="257"/>
            <ac:cxnSpMk id="35" creationId="{867AD5AE-9806-61FE-A077-227CB8807CD2}"/>
          </ac:cxnSpMkLst>
        </pc:cxnChg>
        <pc:cxnChg chg="del mod">
          <ac:chgData name="Héctor Cañeque Rufo" userId="6da3b7e2-2289-4c25-b14d-207ec07af19d" providerId="ADAL" clId="{110670A2-31F1-46D6-B9C0-FFC839AF2B13}" dt="2023-10-11T16:32:38.723" v="4593" actId="478"/>
          <ac:cxnSpMkLst>
            <pc:docMk/>
            <pc:sldMk cId="3649846329" sldId="257"/>
            <ac:cxnSpMk id="36" creationId="{15215182-DFCF-86BC-6E0A-5B38F46F988D}"/>
          </ac:cxnSpMkLst>
        </pc:cxnChg>
        <pc:cxnChg chg="del mod">
          <ac:chgData name="Héctor Cañeque Rufo" userId="6da3b7e2-2289-4c25-b14d-207ec07af19d" providerId="ADAL" clId="{110670A2-31F1-46D6-B9C0-FFC839AF2B13}" dt="2023-10-11T16:32:38.723" v="4593" actId="478"/>
          <ac:cxnSpMkLst>
            <pc:docMk/>
            <pc:sldMk cId="3649846329" sldId="257"/>
            <ac:cxnSpMk id="37" creationId="{A3292BD2-D930-9637-CD75-8154B3380FCD}"/>
          </ac:cxnSpMkLst>
        </pc:cxnChg>
        <pc:cxnChg chg="del mod">
          <ac:chgData name="Héctor Cañeque Rufo" userId="6da3b7e2-2289-4c25-b14d-207ec07af19d" providerId="ADAL" clId="{110670A2-31F1-46D6-B9C0-FFC839AF2B13}" dt="2023-10-11T16:31:57.666" v="4590" actId="478"/>
          <ac:cxnSpMkLst>
            <pc:docMk/>
            <pc:sldMk cId="3649846329" sldId="257"/>
            <ac:cxnSpMk id="68" creationId="{26339FD0-CCE4-3BC1-702A-363E58A0C1A4}"/>
          </ac:cxnSpMkLst>
        </pc:cxnChg>
        <pc:cxnChg chg="del mod">
          <ac:chgData name="Héctor Cañeque Rufo" userId="6da3b7e2-2289-4c25-b14d-207ec07af19d" providerId="ADAL" clId="{110670A2-31F1-46D6-B9C0-FFC839AF2B13}" dt="2023-10-11T16:31:57.666" v="4590" actId="478"/>
          <ac:cxnSpMkLst>
            <pc:docMk/>
            <pc:sldMk cId="3649846329" sldId="257"/>
            <ac:cxnSpMk id="69" creationId="{A0C591B3-3D32-0F74-A2DE-A26398AD21F7}"/>
          </ac:cxnSpMkLst>
        </pc:cxnChg>
        <pc:cxnChg chg="del mod">
          <ac:chgData name="Héctor Cañeque Rufo" userId="6da3b7e2-2289-4c25-b14d-207ec07af19d" providerId="ADAL" clId="{110670A2-31F1-46D6-B9C0-FFC839AF2B13}" dt="2023-10-11T16:31:57.666" v="4590" actId="478"/>
          <ac:cxnSpMkLst>
            <pc:docMk/>
            <pc:sldMk cId="3649846329" sldId="257"/>
            <ac:cxnSpMk id="70" creationId="{E9672DA3-7554-AE64-FB72-C50551A1EF27}"/>
          </ac:cxnSpMkLst>
        </pc:cxnChg>
        <pc:cxnChg chg="del mod">
          <ac:chgData name="Héctor Cañeque Rufo" userId="6da3b7e2-2289-4c25-b14d-207ec07af19d" providerId="ADAL" clId="{110670A2-31F1-46D6-B9C0-FFC839AF2B13}" dt="2023-10-11T16:31:57.666" v="4590" actId="478"/>
          <ac:cxnSpMkLst>
            <pc:docMk/>
            <pc:sldMk cId="3649846329" sldId="257"/>
            <ac:cxnSpMk id="71" creationId="{9CBFBA0F-1830-F5B9-4334-BC330FE65AEF}"/>
          </ac:cxnSpMkLst>
        </pc:cxnChg>
        <pc:cxnChg chg="del mod">
          <ac:chgData name="Héctor Cañeque Rufo" userId="6da3b7e2-2289-4c25-b14d-207ec07af19d" providerId="ADAL" clId="{110670A2-31F1-46D6-B9C0-FFC839AF2B13}" dt="2023-10-11T16:31:57.666" v="4590" actId="478"/>
          <ac:cxnSpMkLst>
            <pc:docMk/>
            <pc:sldMk cId="3649846329" sldId="257"/>
            <ac:cxnSpMk id="72" creationId="{3C6B8486-CB0B-EDC7-F2A8-8AE40CF34FEA}"/>
          </ac:cxnSpMkLst>
        </pc:cxnChg>
        <pc:cxnChg chg="del mod">
          <ac:chgData name="Héctor Cañeque Rufo" userId="6da3b7e2-2289-4c25-b14d-207ec07af19d" providerId="ADAL" clId="{110670A2-31F1-46D6-B9C0-FFC839AF2B13}" dt="2023-10-11T16:32:18.758" v="4591" actId="478"/>
          <ac:cxnSpMkLst>
            <pc:docMk/>
            <pc:sldMk cId="3649846329" sldId="257"/>
            <ac:cxnSpMk id="73" creationId="{97315F11-A407-3C26-6FE9-98334CBDB143}"/>
          </ac:cxnSpMkLst>
        </pc:cxnChg>
        <pc:cxnChg chg="del mod">
          <ac:chgData name="Héctor Cañeque Rufo" userId="6da3b7e2-2289-4c25-b14d-207ec07af19d" providerId="ADAL" clId="{110670A2-31F1-46D6-B9C0-FFC839AF2B13}" dt="2023-10-11T16:32:38.723" v="4593" actId="478"/>
          <ac:cxnSpMkLst>
            <pc:docMk/>
            <pc:sldMk cId="3649846329" sldId="257"/>
            <ac:cxnSpMk id="74" creationId="{55E40A3E-8C11-EA5B-A419-31DE5234265B}"/>
          </ac:cxnSpMkLst>
        </pc:cxnChg>
        <pc:cxnChg chg="del mod">
          <ac:chgData name="Héctor Cañeque Rufo" userId="6da3b7e2-2289-4c25-b14d-207ec07af19d" providerId="ADAL" clId="{110670A2-31F1-46D6-B9C0-FFC839AF2B13}" dt="2023-10-11T16:32:18.758" v="4591" actId="478"/>
          <ac:cxnSpMkLst>
            <pc:docMk/>
            <pc:sldMk cId="3649846329" sldId="257"/>
            <ac:cxnSpMk id="75" creationId="{E1AE5F78-6BAA-5DDC-2679-5FF621DFE26A}"/>
          </ac:cxnSpMkLst>
        </pc:cxnChg>
        <pc:cxnChg chg="del mod">
          <ac:chgData name="Héctor Cañeque Rufo" userId="6da3b7e2-2289-4c25-b14d-207ec07af19d" providerId="ADAL" clId="{110670A2-31F1-46D6-B9C0-FFC839AF2B13}" dt="2023-10-11T16:32:38.723" v="4593" actId="478"/>
          <ac:cxnSpMkLst>
            <pc:docMk/>
            <pc:sldMk cId="3649846329" sldId="257"/>
            <ac:cxnSpMk id="76" creationId="{72A37287-59DD-1B1A-7E69-E9D09122014F}"/>
          </ac:cxnSpMkLst>
        </pc:cxnChg>
        <pc:cxnChg chg="del mod">
          <ac:chgData name="Héctor Cañeque Rufo" userId="6da3b7e2-2289-4c25-b14d-207ec07af19d" providerId="ADAL" clId="{110670A2-31F1-46D6-B9C0-FFC839AF2B13}" dt="2023-10-11T16:32:38.723" v="4593" actId="478"/>
          <ac:cxnSpMkLst>
            <pc:docMk/>
            <pc:sldMk cId="3649846329" sldId="257"/>
            <ac:cxnSpMk id="77" creationId="{492F0C8B-2111-8006-B09C-9F3B72AA0F9F}"/>
          </ac:cxnSpMkLst>
        </pc:cxnChg>
        <pc:cxnChg chg="del mod">
          <ac:chgData name="Héctor Cañeque Rufo" userId="6da3b7e2-2289-4c25-b14d-207ec07af19d" providerId="ADAL" clId="{110670A2-31F1-46D6-B9C0-FFC839AF2B13}" dt="2023-10-11T16:32:38.723" v="4593" actId="478"/>
          <ac:cxnSpMkLst>
            <pc:docMk/>
            <pc:sldMk cId="3649846329" sldId="257"/>
            <ac:cxnSpMk id="78" creationId="{E79EA42C-7503-7FB6-B59C-732821C32E9B}"/>
          </ac:cxnSpMkLst>
        </pc:cxnChg>
        <pc:cxnChg chg="del mod">
          <ac:chgData name="Héctor Cañeque Rufo" userId="6da3b7e2-2289-4c25-b14d-207ec07af19d" providerId="ADAL" clId="{110670A2-31F1-46D6-B9C0-FFC839AF2B13}" dt="2023-10-11T16:32:38.723" v="4593" actId="478"/>
          <ac:cxnSpMkLst>
            <pc:docMk/>
            <pc:sldMk cId="3649846329" sldId="257"/>
            <ac:cxnSpMk id="79" creationId="{13EE4710-0930-CE27-5A92-062B3EEE04CD}"/>
          </ac:cxnSpMkLst>
        </pc:cxnChg>
        <pc:cxnChg chg="del mod">
          <ac:chgData name="Héctor Cañeque Rufo" userId="6da3b7e2-2289-4c25-b14d-207ec07af19d" providerId="ADAL" clId="{110670A2-31F1-46D6-B9C0-FFC839AF2B13}" dt="2023-10-11T16:31:57.666" v="4590" actId="478"/>
          <ac:cxnSpMkLst>
            <pc:docMk/>
            <pc:sldMk cId="3649846329" sldId="257"/>
            <ac:cxnSpMk id="87" creationId="{2F1BC882-E0F1-A5E3-E75D-5357A574800A}"/>
          </ac:cxnSpMkLst>
        </pc:cxnChg>
        <pc:cxnChg chg="del mod">
          <ac:chgData name="Héctor Cañeque Rufo" userId="6da3b7e2-2289-4c25-b14d-207ec07af19d" providerId="ADAL" clId="{110670A2-31F1-46D6-B9C0-FFC839AF2B13}" dt="2023-10-11T16:31:57.666" v="4590" actId="478"/>
          <ac:cxnSpMkLst>
            <pc:docMk/>
            <pc:sldMk cId="3649846329" sldId="257"/>
            <ac:cxnSpMk id="88" creationId="{89640D8D-2783-7796-2BE7-A35283BDD04F}"/>
          </ac:cxnSpMkLst>
        </pc:cxnChg>
        <pc:cxnChg chg="del mod">
          <ac:chgData name="Héctor Cañeque Rufo" userId="6da3b7e2-2289-4c25-b14d-207ec07af19d" providerId="ADAL" clId="{110670A2-31F1-46D6-B9C0-FFC839AF2B13}" dt="2023-10-11T16:31:57.666" v="4590" actId="478"/>
          <ac:cxnSpMkLst>
            <pc:docMk/>
            <pc:sldMk cId="3649846329" sldId="257"/>
            <ac:cxnSpMk id="89" creationId="{081CE989-CCDA-101D-D6E4-96D931B1D195}"/>
          </ac:cxnSpMkLst>
        </pc:cxnChg>
        <pc:cxnChg chg="del mod">
          <ac:chgData name="Héctor Cañeque Rufo" userId="6da3b7e2-2289-4c25-b14d-207ec07af19d" providerId="ADAL" clId="{110670A2-31F1-46D6-B9C0-FFC839AF2B13}" dt="2023-10-11T16:31:57.666" v="4590" actId="478"/>
          <ac:cxnSpMkLst>
            <pc:docMk/>
            <pc:sldMk cId="3649846329" sldId="257"/>
            <ac:cxnSpMk id="90" creationId="{87EAF470-1FA0-51B9-7F97-4855781D60B9}"/>
          </ac:cxnSpMkLst>
        </pc:cxnChg>
        <pc:cxnChg chg="del mod">
          <ac:chgData name="Héctor Cañeque Rufo" userId="6da3b7e2-2289-4c25-b14d-207ec07af19d" providerId="ADAL" clId="{110670A2-31F1-46D6-B9C0-FFC839AF2B13}" dt="2023-10-11T16:31:57.666" v="4590" actId="478"/>
          <ac:cxnSpMkLst>
            <pc:docMk/>
            <pc:sldMk cId="3649846329" sldId="257"/>
            <ac:cxnSpMk id="91" creationId="{00F99A79-AEFC-D97E-43D5-A35D8099A3D9}"/>
          </ac:cxnSpMkLst>
        </pc:cxnChg>
        <pc:cxnChg chg="del mod">
          <ac:chgData name="Héctor Cañeque Rufo" userId="6da3b7e2-2289-4c25-b14d-207ec07af19d" providerId="ADAL" clId="{110670A2-31F1-46D6-B9C0-FFC839AF2B13}" dt="2023-10-11T16:32:46.379" v="4594" actId="478"/>
          <ac:cxnSpMkLst>
            <pc:docMk/>
            <pc:sldMk cId="3649846329" sldId="257"/>
            <ac:cxnSpMk id="92" creationId="{0ADCEB12-1DEC-0AF8-42B7-83811106E1D2}"/>
          </ac:cxnSpMkLst>
        </pc:cxnChg>
        <pc:cxnChg chg="del mod">
          <ac:chgData name="Héctor Cañeque Rufo" userId="6da3b7e2-2289-4c25-b14d-207ec07af19d" providerId="ADAL" clId="{110670A2-31F1-46D6-B9C0-FFC839AF2B13}" dt="2023-10-11T16:33:00.015" v="4595" actId="478"/>
          <ac:cxnSpMkLst>
            <pc:docMk/>
            <pc:sldMk cId="3649846329" sldId="257"/>
            <ac:cxnSpMk id="93" creationId="{C3B929C3-4BCA-7967-4C59-55F974D48712}"/>
          </ac:cxnSpMkLst>
        </pc:cxnChg>
        <pc:cxnChg chg="del mod">
          <ac:chgData name="Héctor Cañeque Rufo" userId="6da3b7e2-2289-4c25-b14d-207ec07af19d" providerId="ADAL" clId="{110670A2-31F1-46D6-B9C0-FFC839AF2B13}" dt="2023-10-11T16:33:00.015" v="4595" actId="478"/>
          <ac:cxnSpMkLst>
            <pc:docMk/>
            <pc:sldMk cId="3649846329" sldId="257"/>
            <ac:cxnSpMk id="94" creationId="{F109E6EF-781F-3041-0AE1-08BEB2A744F8}"/>
          </ac:cxnSpMkLst>
        </pc:cxnChg>
        <pc:cxnChg chg="del mod">
          <ac:chgData name="Héctor Cañeque Rufo" userId="6da3b7e2-2289-4c25-b14d-207ec07af19d" providerId="ADAL" clId="{110670A2-31F1-46D6-B9C0-FFC839AF2B13}" dt="2023-10-11T16:33:00.015" v="4595" actId="478"/>
          <ac:cxnSpMkLst>
            <pc:docMk/>
            <pc:sldMk cId="3649846329" sldId="257"/>
            <ac:cxnSpMk id="95" creationId="{73898372-D8CC-05E3-68B5-4E4404DBC118}"/>
          </ac:cxnSpMkLst>
        </pc:cxnChg>
        <pc:cxnChg chg="del mod">
          <ac:chgData name="Héctor Cañeque Rufo" userId="6da3b7e2-2289-4c25-b14d-207ec07af19d" providerId="ADAL" clId="{110670A2-31F1-46D6-B9C0-FFC839AF2B13}" dt="2023-10-11T16:33:00.015" v="4595" actId="478"/>
          <ac:cxnSpMkLst>
            <pc:docMk/>
            <pc:sldMk cId="3649846329" sldId="257"/>
            <ac:cxnSpMk id="96" creationId="{4B272CFF-990D-60FF-1DE6-289BC0C397DF}"/>
          </ac:cxnSpMkLst>
        </pc:cxnChg>
        <pc:cxnChg chg="del mod">
          <ac:chgData name="Héctor Cañeque Rufo" userId="6da3b7e2-2289-4c25-b14d-207ec07af19d" providerId="ADAL" clId="{110670A2-31F1-46D6-B9C0-FFC839AF2B13}" dt="2023-10-11T16:33:00.015" v="4595" actId="478"/>
          <ac:cxnSpMkLst>
            <pc:docMk/>
            <pc:sldMk cId="3649846329" sldId="257"/>
            <ac:cxnSpMk id="97" creationId="{46AAF33D-0F91-C175-186F-C22BF0B61B7C}"/>
          </ac:cxnSpMkLst>
        </pc:cxnChg>
        <pc:cxnChg chg="del mod">
          <ac:chgData name="Héctor Cañeque Rufo" userId="6da3b7e2-2289-4c25-b14d-207ec07af19d" providerId="ADAL" clId="{110670A2-31F1-46D6-B9C0-FFC839AF2B13}" dt="2023-10-11T16:33:00.015" v="4595" actId="478"/>
          <ac:cxnSpMkLst>
            <pc:docMk/>
            <pc:sldMk cId="3649846329" sldId="257"/>
            <ac:cxnSpMk id="98" creationId="{902E5EE3-61E1-65F2-13F8-E1E7CB95AF9B}"/>
          </ac:cxnSpMkLst>
        </pc:cxnChg>
        <pc:cxnChg chg="mod">
          <ac:chgData name="Héctor Cañeque Rufo" userId="6da3b7e2-2289-4c25-b14d-207ec07af19d" providerId="ADAL" clId="{110670A2-31F1-46D6-B9C0-FFC839AF2B13}" dt="2023-10-11T16:31:22.229" v="4584"/>
          <ac:cxnSpMkLst>
            <pc:docMk/>
            <pc:sldMk cId="3649846329" sldId="257"/>
            <ac:cxnSpMk id="106" creationId="{B6FD2CC1-2D1D-F91D-FAD6-6BC2815C9327}"/>
          </ac:cxnSpMkLst>
        </pc:cxnChg>
        <pc:cxnChg chg="mod">
          <ac:chgData name="Héctor Cañeque Rufo" userId="6da3b7e2-2289-4c25-b14d-207ec07af19d" providerId="ADAL" clId="{110670A2-31F1-46D6-B9C0-FFC839AF2B13}" dt="2023-10-11T16:31:22.229" v="4584"/>
          <ac:cxnSpMkLst>
            <pc:docMk/>
            <pc:sldMk cId="3649846329" sldId="257"/>
            <ac:cxnSpMk id="107" creationId="{03B9B26B-C551-D5B4-50B9-63416678D96F}"/>
          </ac:cxnSpMkLst>
        </pc:cxnChg>
        <pc:cxnChg chg="mod">
          <ac:chgData name="Héctor Cañeque Rufo" userId="6da3b7e2-2289-4c25-b14d-207ec07af19d" providerId="ADAL" clId="{110670A2-31F1-46D6-B9C0-FFC839AF2B13}" dt="2023-10-11T16:31:22.229" v="4584"/>
          <ac:cxnSpMkLst>
            <pc:docMk/>
            <pc:sldMk cId="3649846329" sldId="257"/>
            <ac:cxnSpMk id="108" creationId="{2C776B20-DBA0-A6F0-4D5C-D44C1FD39DC9}"/>
          </ac:cxnSpMkLst>
        </pc:cxnChg>
        <pc:cxnChg chg="mod">
          <ac:chgData name="Héctor Cañeque Rufo" userId="6da3b7e2-2289-4c25-b14d-207ec07af19d" providerId="ADAL" clId="{110670A2-31F1-46D6-B9C0-FFC839AF2B13}" dt="2023-10-11T16:31:22.229" v="4584"/>
          <ac:cxnSpMkLst>
            <pc:docMk/>
            <pc:sldMk cId="3649846329" sldId="257"/>
            <ac:cxnSpMk id="109" creationId="{E0D6B8C0-1CE4-1F34-3888-62CDCE02EFAE}"/>
          </ac:cxnSpMkLst>
        </pc:cxnChg>
        <pc:cxnChg chg="mod">
          <ac:chgData name="Héctor Cañeque Rufo" userId="6da3b7e2-2289-4c25-b14d-207ec07af19d" providerId="ADAL" clId="{110670A2-31F1-46D6-B9C0-FFC839AF2B13}" dt="2023-10-11T16:31:22.229" v="4584"/>
          <ac:cxnSpMkLst>
            <pc:docMk/>
            <pc:sldMk cId="3649846329" sldId="257"/>
            <ac:cxnSpMk id="110" creationId="{93D94DA8-4A51-03EC-C2D3-73CCC1229D72}"/>
          </ac:cxnSpMkLst>
        </pc:cxnChg>
        <pc:cxnChg chg="mod">
          <ac:chgData name="Héctor Cañeque Rufo" userId="6da3b7e2-2289-4c25-b14d-207ec07af19d" providerId="ADAL" clId="{110670A2-31F1-46D6-B9C0-FFC839AF2B13}" dt="2023-10-11T16:36:31.874" v="5009" actId="1036"/>
          <ac:cxnSpMkLst>
            <pc:docMk/>
            <pc:sldMk cId="3649846329" sldId="257"/>
            <ac:cxnSpMk id="111" creationId="{0243AEFB-AEF7-9C23-40D1-ED6E4F27A7C8}"/>
          </ac:cxnSpMkLst>
        </pc:cxnChg>
        <pc:cxnChg chg="mod">
          <ac:chgData name="Héctor Cañeque Rufo" userId="6da3b7e2-2289-4c25-b14d-207ec07af19d" providerId="ADAL" clId="{110670A2-31F1-46D6-B9C0-FFC839AF2B13}" dt="2023-10-11T16:36:31.874" v="5009" actId="1036"/>
          <ac:cxnSpMkLst>
            <pc:docMk/>
            <pc:sldMk cId="3649846329" sldId="257"/>
            <ac:cxnSpMk id="112" creationId="{97605C80-1977-F8E7-BD25-C8BB5DDDBBA5}"/>
          </ac:cxnSpMkLst>
        </pc:cxnChg>
        <pc:cxnChg chg="mod">
          <ac:chgData name="Héctor Cañeque Rufo" userId="6da3b7e2-2289-4c25-b14d-207ec07af19d" providerId="ADAL" clId="{110670A2-31F1-46D6-B9C0-FFC839AF2B13}" dt="2023-10-11T16:36:31.874" v="5009" actId="1036"/>
          <ac:cxnSpMkLst>
            <pc:docMk/>
            <pc:sldMk cId="3649846329" sldId="257"/>
            <ac:cxnSpMk id="113" creationId="{0A191429-880D-B19C-7325-ED91C832ACAC}"/>
          </ac:cxnSpMkLst>
        </pc:cxnChg>
        <pc:cxnChg chg="mod">
          <ac:chgData name="Héctor Cañeque Rufo" userId="6da3b7e2-2289-4c25-b14d-207ec07af19d" providerId="ADAL" clId="{110670A2-31F1-46D6-B9C0-FFC839AF2B13}" dt="2023-10-11T16:36:31.874" v="5009" actId="1036"/>
          <ac:cxnSpMkLst>
            <pc:docMk/>
            <pc:sldMk cId="3649846329" sldId="257"/>
            <ac:cxnSpMk id="114" creationId="{A643A6B1-F757-A5CF-F481-6179EEC6C82F}"/>
          </ac:cxnSpMkLst>
        </pc:cxnChg>
        <pc:cxnChg chg="mod">
          <ac:chgData name="Héctor Cañeque Rufo" userId="6da3b7e2-2289-4c25-b14d-207ec07af19d" providerId="ADAL" clId="{110670A2-31F1-46D6-B9C0-FFC839AF2B13}" dt="2023-10-11T16:36:31.874" v="5009" actId="1036"/>
          <ac:cxnSpMkLst>
            <pc:docMk/>
            <pc:sldMk cId="3649846329" sldId="257"/>
            <ac:cxnSpMk id="115" creationId="{DB90E4C7-EA8D-256D-E5A8-2D982AB9CE7A}"/>
          </ac:cxnSpMkLst>
        </pc:cxnChg>
        <pc:cxnChg chg="mod">
          <ac:chgData name="Héctor Cañeque Rufo" userId="6da3b7e2-2289-4c25-b14d-207ec07af19d" providerId="ADAL" clId="{110670A2-31F1-46D6-B9C0-FFC839AF2B13}" dt="2023-10-11T16:36:31.874" v="5009" actId="1036"/>
          <ac:cxnSpMkLst>
            <pc:docMk/>
            <pc:sldMk cId="3649846329" sldId="257"/>
            <ac:cxnSpMk id="116" creationId="{E2D035B3-F736-8B1B-B975-64055C272906}"/>
          </ac:cxnSpMkLst>
        </pc:cxnChg>
        <pc:cxnChg chg="mod">
          <ac:chgData name="Héctor Cañeque Rufo" userId="6da3b7e2-2289-4c25-b14d-207ec07af19d" providerId="ADAL" clId="{110670A2-31F1-46D6-B9C0-FFC839AF2B13}" dt="2023-10-11T16:36:31.874" v="5009" actId="1036"/>
          <ac:cxnSpMkLst>
            <pc:docMk/>
            <pc:sldMk cId="3649846329" sldId="257"/>
            <ac:cxnSpMk id="117" creationId="{81AEDD31-1CE1-EFEB-4EEF-39E540E4EA84}"/>
          </ac:cxnSpMkLst>
        </pc:cxnChg>
      </pc:sldChg>
      <pc:sldChg chg="delSp modSp add del mod">
        <pc:chgData name="Héctor Cañeque Rufo" userId="6da3b7e2-2289-4c25-b14d-207ec07af19d" providerId="ADAL" clId="{110670A2-31F1-46D6-B9C0-FFC839AF2B13}" dt="2023-10-11T15:57:49.998" v="2847" actId="2696"/>
        <pc:sldMkLst>
          <pc:docMk/>
          <pc:sldMk cId="3796459880" sldId="257"/>
        </pc:sldMkLst>
        <pc:grpChg chg="del">
          <ac:chgData name="Héctor Cañeque Rufo" userId="6da3b7e2-2289-4c25-b14d-207ec07af19d" providerId="ADAL" clId="{110670A2-31F1-46D6-B9C0-FFC839AF2B13}" dt="2023-10-11T15:53:16.625" v="2424" actId="165"/>
          <ac:grpSpMkLst>
            <pc:docMk/>
            <pc:sldMk cId="3796459880" sldId="257"/>
            <ac:grpSpMk id="20" creationId="{1D3C2E6B-EC4A-8F30-1DF8-A61E4987D751}"/>
          </ac:grpSpMkLst>
        </pc:grpChg>
        <pc:picChg chg="mod topLvl modCrop">
          <ac:chgData name="Héctor Cañeque Rufo" userId="6da3b7e2-2289-4c25-b14d-207ec07af19d" providerId="ADAL" clId="{110670A2-31F1-46D6-B9C0-FFC839AF2B13}" dt="2023-10-11T15:55:34.058" v="2818" actId="1038"/>
          <ac:picMkLst>
            <pc:docMk/>
            <pc:sldMk cId="3796459880" sldId="257"/>
            <ac:picMk id="12" creationId="{9C80E917-8625-BD51-DB49-917151A4F2D2}"/>
          </ac:picMkLst>
        </pc:picChg>
        <pc:picChg chg="mod topLvl modCrop">
          <ac:chgData name="Héctor Cañeque Rufo" userId="6da3b7e2-2289-4c25-b14d-207ec07af19d" providerId="ADAL" clId="{110670A2-31F1-46D6-B9C0-FFC839AF2B13}" dt="2023-10-11T15:55:38.386" v="2837" actId="1037"/>
          <ac:picMkLst>
            <pc:docMk/>
            <pc:sldMk cId="3796459880" sldId="257"/>
            <ac:picMk id="13" creationId="{7A3A51E2-91FA-7E94-C135-E09B6717C731}"/>
          </ac:picMkLst>
        </pc:picChg>
        <pc:picChg chg="mod topLvl">
          <ac:chgData name="Héctor Cañeque Rufo" userId="6da3b7e2-2289-4c25-b14d-207ec07af19d" providerId="ADAL" clId="{110670A2-31F1-46D6-B9C0-FFC839AF2B13}" dt="2023-10-11T15:55:05.172" v="2660" actId="14100"/>
          <ac:picMkLst>
            <pc:docMk/>
            <pc:sldMk cId="3796459880" sldId="257"/>
            <ac:picMk id="18" creationId="{DA55C7F4-6D6B-A553-D147-77A365D4BCF8}"/>
          </ac:picMkLst>
        </pc:picChg>
        <pc:picChg chg="mod topLvl">
          <ac:chgData name="Héctor Cañeque Rufo" userId="6da3b7e2-2289-4c25-b14d-207ec07af19d" providerId="ADAL" clId="{110670A2-31F1-46D6-B9C0-FFC839AF2B13}" dt="2023-10-11T15:55:21.328" v="2687" actId="1037"/>
          <ac:picMkLst>
            <pc:docMk/>
            <pc:sldMk cId="3796459880" sldId="257"/>
            <ac:picMk id="19" creationId="{9724040B-0196-9AD6-E635-0094BB96A211}"/>
          </ac:picMkLst>
        </pc:picChg>
      </pc:sldChg>
      <pc:sldChg chg="addSp modSp add del mod">
        <pc:chgData name="Héctor Cañeque Rufo" userId="6da3b7e2-2289-4c25-b14d-207ec07af19d" providerId="ADAL" clId="{110670A2-31F1-46D6-B9C0-FFC839AF2B13}" dt="2023-10-11T16:40:16.947" v="5499" actId="2696"/>
        <pc:sldMkLst>
          <pc:docMk/>
          <pc:sldMk cId="3887338285" sldId="258"/>
        </pc:sldMkLst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4" creationId="{3D1687BC-F67D-68E3-D0A4-1ED6DC8028BF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5" creationId="{6CA7DBCA-1390-654D-6A5D-561AA075A9EE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8" creationId="{BAFD454C-E1F0-7A7B-6160-43CB8B19FC60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9" creationId="{79D9A17E-192D-9225-8432-52E29A96055A}"/>
          </ac:spMkLst>
        </pc:spChg>
        <pc:spChg chg="mod">
          <ac:chgData name="Héctor Cañeque Rufo" userId="6da3b7e2-2289-4c25-b14d-207ec07af19d" providerId="ADAL" clId="{110670A2-31F1-46D6-B9C0-FFC839AF2B13}" dt="2023-10-11T16:16:27.939" v="3562" actId="1076"/>
          <ac:spMkLst>
            <pc:docMk/>
            <pc:sldMk cId="3887338285" sldId="258"/>
            <ac:spMk id="22" creationId="{6A807A99-5770-26EF-83F9-A6A8D108BAE3}"/>
          </ac:spMkLst>
        </pc:spChg>
        <pc:spChg chg="mod">
          <ac:chgData name="Héctor Cañeque Rufo" userId="6da3b7e2-2289-4c25-b14d-207ec07af19d" providerId="ADAL" clId="{110670A2-31F1-46D6-B9C0-FFC839AF2B13}" dt="2023-10-11T16:18:23.912" v="3598" actId="1076"/>
          <ac:spMkLst>
            <pc:docMk/>
            <pc:sldMk cId="3887338285" sldId="258"/>
            <ac:spMk id="23" creationId="{61A91876-C028-5567-9581-C18C4AAD189F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25" creationId="{B821D665-ACA0-37B2-3521-05FDB3D5B649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27" creationId="{618FE154-B9E1-1C75-ACB6-4785814896FC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31" creationId="{F9E35097-EF14-9BE1-377A-452C5F39F16E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32" creationId="{5F6582EC-2D2B-B027-78CE-7F133DAFDE3F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33" creationId="{CD675422-E34C-9A57-DEF3-A3B4E8EE9E4D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34" creationId="{41FB1DBB-6F05-21D0-3ED4-4F0FE2CA9F46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35" creationId="{67C54CFE-8BA1-7943-15E1-189D3140BA35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36" creationId="{D32A0608-9489-CD8E-38A4-947CF3A14E82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37" creationId="{739084E0-1586-B95C-2F14-0A8CA72671B4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38" creationId="{DE664631-CF61-CEA9-8CEC-E065340E810B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39" creationId="{D31D71EA-5AC6-7010-2288-3AB365C3FB6E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40" creationId="{96723D2D-FEB1-F13E-6E8D-9EA72489042C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41" creationId="{D5B45246-0CEB-94D6-354E-9C2F520838E0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42" creationId="{8E8490B3-77CD-D125-0953-C62069686F12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43" creationId="{1A44A80D-EB58-AD6B-C1AC-9C1931D36119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44" creationId="{734352BE-56E8-60C7-8F24-387A6BF6D92F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45" creationId="{74A0D1EC-5B3C-3D05-42C0-F04984D76C23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46" creationId="{C9B96D39-13B5-9A21-E502-F3F3DC2B2A67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47" creationId="{F4FFD6E3-A634-756F-8DDD-079C4BC5EE11}"/>
          </ac:spMkLst>
        </pc:spChg>
        <pc:grpChg chg="add mod">
          <ac:chgData name="Héctor Cañeque Rufo" userId="6da3b7e2-2289-4c25-b14d-207ec07af19d" providerId="ADAL" clId="{110670A2-31F1-46D6-B9C0-FFC839AF2B13}" dt="2023-10-11T16:39:39.729" v="5489"/>
          <ac:grpSpMkLst>
            <pc:docMk/>
            <pc:sldMk cId="3887338285" sldId="258"/>
            <ac:grpSpMk id="2" creationId="{79DC0F99-6F31-3097-AA3A-4E6829BE8A7C}"/>
          </ac:grpSpMkLst>
        </pc:grpChg>
        <pc:grpChg chg="mod">
          <ac:chgData name="Héctor Cañeque Rufo" userId="6da3b7e2-2289-4c25-b14d-207ec07af19d" providerId="ADAL" clId="{110670A2-31F1-46D6-B9C0-FFC839AF2B13}" dt="2023-10-11T16:39:39.729" v="5489"/>
          <ac:grpSpMkLst>
            <pc:docMk/>
            <pc:sldMk cId="3887338285" sldId="258"/>
            <ac:grpSpMk id="3" creationId="{2D1392EB-1617-4BB4-3A70-8BC1CCD44B39}"/>
          </ac:grpSpMkLst>
        </pc:grpChg>
        <pc:grpChg chg="mod">
          <ac:chgData name="Héctor Cañeque Rufo" userId="6da3b7e2-2289-4c25-b14d-207ec07af19d" providerId="ADAL" clId="{110670A2-31F1-46D6-B9C0-FFC839AF2B13}" dt="2023-10-11T16:39:39.729" v="5489"/>
          <ac:grpSpMkLst>
            <pc:docMk/>
            <pc:sldMk cId="3887338285" sldId="258"/>
            <ac:grpSpMk id="10" creationId="{7C9EF5D7-E6C9-CD77-C8C0-21971487D499}"/>
          </ac:grpSpMkLst>
        </pc:grpChg>
        <pc:grpChg chg="mod">
          <ac:chgData name="Héctor Cañeque Rufo" userId="6da3b7e2-2289-4c25-b14d-207ec07af19d" providerId="ADAL" clId="{110670A2-31F1-46D6-B9C0-FFC839AF2B13}" dt="2023-10-11T16:39:39.729" v="5489"/>
          <ac:grpSpMkLst>
            <pc:docMk/>
            <pc:sldMk cId="3887338285" sldId="258"/>
            <ac:grpSpMk id="17" creationId="{29393ECE-E3F3-6338-5C45-92F0FF358473}"/>
          </ac:grpSpMkLst>
        </pc:grpChg>
        <pc:grpChg chg="mod">
          <ac:chgData name="Héctor Cañeque Rufo" userId="6da3b7e2-2289-4c25-b14d-207ec07af19d" providerId="ADAL" clId="{110670A2-31F1-46D6-B9C0-FFC839AF2B13}" dt="2023-10-11T16:39:39.729" v="5489"/>
          <ac:grpSpMkLst>
            <pc:docMk/>
            <pc:sldMk cId="3887338285" sldId="258"/>
            <ac:grpSpMk id="20" creationId="{3ADB1DC9-C50A-7FBC-C7AD-B20E49A1F719}"/>
          </ac:grpSpMkLst>
        </pc:grpChg>
        <pc:grpChg chg="mod">
          <ac:chgData name="Héctor Cañeque Rufo" userId="6da3b7e2-2289-4c25-b14d-207ec07af19d" providerId="ADAL" clId="{110670A2-31F1-46D6-B9C0-FFC839AF2B13}" dt="2023-10-11T16:39:39.729" v="5489"/>
          <ac:grpSpMkLst>
            <pc:docMk/>
            <pc:sldMk cId="3887338285" sldId="258"/>
            <ac:grpSpMk id="30" creationId="{EEE90FA6-AFD9-98B9-EB37-BE4ACCA8B2E9}"/>
          </ac:grpSpMkLst>
        </pc:grpChg>
        <pc:picChg chg="mod">
          <ac:chgData name="Héctor Cañeque Rufo" userId="6da3b7e2-2289-4c25-b14d-207ec07af19d" providerId="ADAL" clId="{110670A2-31F1-46D6-B9C0-FFC839AF2B13}" dt="2023-10-11T16:19:21.987" v="3616" actId="1076"/>
          <ac:picMkLst>
            <pc:docMk/>
            <pc:sldMk cId="3887338285" sldId="258"/>
            <ac:picMk id="6" creationId="{C47E6BA4-4479-B515-6C61-9218E35EA25F}"/>
          </ac:picMkLst>
        </pc:picChg>
        <pc:picChg chg="mod">
          <ac:chgData name="Héctor Cañeque Rufo" userId="6da3b7e2-2289-4c25-b14d-207ec07af19d" providerId="ADAL" clId="{110670A2-31F1-46D6-B9C0-FFC839AF2B13}" dt="2023-10-11T16:18:53.783" v="3605" actId="1076"/>
          <ac:picMkLst>
            <pc:docMk/>
            <pc:sldMk cId="3887338285" sldId="258"/>
            <ac:picMk id="7" creationId="{265DDCD2-73FD-FCC3-6978-A9DF6E8F5A43}"/>
          </ac:picMkLst>
        </pc:picChg>
        <pc:picChg chg="mod">
          <ac:chgData name="Héctor Cañeque Rufo" userId="6da3b7e2-2289-4c25-b14d-207ec07af19d" providerId="ADAL" clId="{110670A2-31F1-46D6-B9C0-FFC839AF2B13}" dt="2023-10-11T16:19:03.897" v="3609" actId="1076"/>
          <ac:picMkLst>
            <pc:docMk/>
            <pc:sldMk cId="3887338285" sldId="258"/>
            <ac:picMk id="12" creationId="{9C80E917-8625-BD51-DB49-917151A4F2D2}"/>
          </ac:picMkLst>
        </pc:picChg>
        <pc:picChg chg="mod">
          <ac:chgData name="Héctor Cañeque Rufo" userId="6da3b7e2-2289-4c25-b14d-207ec07af19d" providerId="ADAL" clId="{110670A2-31F1-46D6-B9C0-FFC839AF2B13}" dt="2023-10-11T16:19:15.141" v="3613" actId="1076"/>
          <ac:picMkLst>
            <pc:docMk/>
            <pc:sldMk cId="3887338285" sldId="258"/>
            <ac:picMk id="13" creationId="{7A3A51E2-91FA-7E94-C135-E09B6717C731}"/>
          </ac:picMkLst>
        </pc:picChg>
        <pc:picChg chg="mod">
          <ac:chgData name="Héctor Cañeque Rufo" userId="6da3b7e2-2289-4c25-b14d-207ec07af19d" providerId="ADAL" clId="{110670A2-31F1-46D6-B9C0-FFC839AF2B13}" dt="2023-10-11T16:19:20.461" v="3615" actId="1076"/>
          <ac:picMkLst>
            <pc:docMk/>
            <pc:sldMk cId="3887338285" sldId="258"/>
            <ac:picMk id="18" creationId="{DA55C7F4-6D6B-A553-D147-77A365D4BCF8}"/>
          </ac:picMkLst>
        </pc:picChg>
        <pc:picChg chg="mod">
          <ac:chgData name="Héctor Cañeque Rufo" userId="6da3b7e2-2289-4c25-b14d-207ec07af19d" providerId="ADAL" clId="{110670A2-31F1-46D6-B9C0-FFC839AF2B13}" dt="2023-10-11T16:19:17.842" v="3614" actId="1076"/>
          <ac:picMkLst>
            <pc:docMk/>
            <pc:sldMk cId="3887338285" sldId="258"/>
            <ac:picMk id="19" creationId="{9724040B-0196-9AD6-E635-0094BB96A211}"/>
          </ac:picMkLst>
        </pc:picChg>
        <pc:picChg chg="mod">
          <ac:chgData name="Héctor Cañeque Rufo" userId="6da3b7e2-2289-4c25-b14d-207ec07af19d" providerId="ADAL" clId="{110670A2-31F1-46D6-B9C0-FFC839AF2B13}" dt="2023-10-11T16:15:08.990" v="3535" actId="1076"/>
          <ac:picMkLst>
            <pc:docMk/>
            <pc:sldMk cId="3887338285" sldId="258"/>
            <ac:picMk id="24" creationId="{14033417-772B-A47C-5E24-843A3841337A}"/>
          </ac:picMkLst>
        </pc:picChg>
        <pc:picChg chg="mod">
          <ac:chgData name="Héctor Cañeque Rufo" userId="6da3b7e2-2289-4c25-b14d-207ec07af19d" providerId="ADAL" clId="{110670A2-31F1-46D6-B9C0-FFC839AF2B13}" dt="2023-10-11T16:16:32.501" v="3564" actId="1076"/>
          <ac:picMkLst>
            <pc:docMk/>
            <pc:sldMk cId="3887338285" sldId="258"/>
            <ac:picMk id="26" creationId="{F01FA171-A34E-7474-ED42-645951E30860}"/>
          </ac:picMkLst>
        </pc:picChg>
        <pc:picChg chg="mod">
          <ac:chgData name="Héctor Cañeque Rufo" userId="6da3b7e2-2289-4c25-b14d-207ec07af19d" providerId="ADAL" clId="{110670A2-31F1-46D6-B9C0-FFC839AF2B13}" dt="2023-10-11T16:39:39.729" v="5489"/>
          <ac:picMkLst>
            <pc:docMk/>
            <pc:sldMk cId="3887338285" sldId="258"/>
            <ac:picMk id="28" creationId="{2012D5F3-0EE8-B7BF-48AB-F1F6781C44CA}"/>
          </ac:picMkLst>
        </pc:picChg>
        <pc:picChg chg="mod">
          <ac:chgData name="Héctor Cañeque Rufo" userId="6da3b7e2-2289-4c25-b14d-207ec07af19d" providerId="ADAL" clId="{110670A2-31F1-46D6-B9C0-FFC839AF2B13}" dt="2023-10-11T16:39:39.729" v="5489"/>
          <ac:picMkLst>
            <pc:docMk/>
            <pc:sldMk cId="3887338285" sldId="258"/>
            <ac:picMk id="29" creationId="{87595A62-BD69-5844-C2A4-BD17268BF121}"/>
          </ac:picMkLst>
        </pc:picChg>
        <pc:cxnChg chg="mod">
          <ac:chgData name="Héctor Cañeque Rufo" userId="6da3b7e2-2289-4c25-b14d-207ec07af19d" providerId="ADAL" clId="{110670A2-31F1-46D6-B9C0-FFC839AF2B13}" dt="2023-10-11T16:39:39.729" v="5489"/>
          <ac:cxnSpMkLst>
            <pc:docMk/>
            <pc:sldMk cId="3887338285" sldId="258"/>
            <ac:cxnSpMk id="11" creationId="{964BD849-CAA0-0D47-5879-D7FCF975E7D5}"/>
          </ac:cxnSpMkLst>
        </pc:cxnChg>
        <pc:cxnChg chg="mod">
          <ac:chgData name="Héctor Cañeque Rufo" userId="6da3b7e2-2289-4c25-b14d-207ec07af19d" providerId="ADAL" clId="{110670A2-31F1-46D6-B9C0-FFC839AF2B13}" dt="2023-10-11T16:39:39.729" v="5489"/>
          <ac:cxnSpMkLst>
            <pc:docMk/>
            <pc:sldMk cId="3887338285" sldId="258"/>
            <ac:cxnSpMk id="14" creationId="{26B8D388-C6EA-01DC-1942-527461F528B3}"/>
          </ac:cxnSpMkLst>
        </pc:cxnChg>
        <pc:cxnChg chg="mod">
          <ac:chgData name="Héctor Cañeque Rufo" userId="6da3b7e2-2289-4c25-b14d-207ec07af19d" providerId="ADAL" clId="{110670A2-31F1-46D6-B9C0-FFC839AF2B13}" dt="2023-10-11T16:39:39.729" v="5489"/>
          <ac:cxnSpMkLst>
            <pc:docMk/>
            <pc:sldMk cId="3887338285" sldId="258"/>
            <ac:cxnSpMk id="15" creationId="{A82300E1-6349-F41E-5705-49DFE3C43FC4}"/>
          </ac:cxnSpMkLst>
        </pc:cxnChg>
        <pc:cxnChg chg="mod">
          <ac:chgData name="Héctor Cañeque Rufo" userId="6da3b7e2-2289-4c25-b14d-207ec07af19d" providerId="ADAL" clId="{110670A2-31F1-46D6-B9C0-FFC839AF2B13}" dt="2023-10-11T16:39:39.729" v="5489"/>
          <ac:cxnSpMkLst>
            <pc:docMk/>
            <pc:sldMk cId="3887338285" sldId="258"/>
            <ac:cxnSpMk id="16" creationId="{DD0B11B1-8973-9AF7-4B3A-D4680CDF7B40}"/>
          </ac:cxnSpMkLst>
        </pc:cxnChg>
        <pc:cxnChg chg="mod">
          <ac:chgData name="Héctor Cañeque Rufo" userId="6da3b7e2-2289-4c25-b14d-207ec07af19d" providerId="ADAL" clId="{110670A2-31F1-46D6-B9C0-FFC839AF2B13}" dt="2023-10-11T16:39:39.729" v="5489"/>
          <ac:cxnSpMkLst>
            <pc:docMk/>
            <pc:sldMk cId="3887338285" sldId="258"/>
            <ac:cxnSpMk id="48" creationId="{00C7AE57-56DA-B0A3-FBD1-D07641AFD4D7}"/>
          </ac:cxnSpMkLst>
        </pc:cxnChg>
        <pc:cxnChg chg="mod">
          <ac:chgData name="Héctor Cañeque Rufo" userId="6da3b7e2-2289-4c25-b14d-207ec07af19d" providerId="ADAL" clId="{110670A2-31F1-46D6-B9C0-FFC839AF2B13}" dt="2023-10-11T16:39:39.729" v="5489"/>
          <ac:cxnSpMkLst>
            <pc:docMk/>
            <pc:sldMk cId="3887338285" sldId="258"/>
            <ac:cxnSpMk id="49" creationId="{56D20DA7-1C13-11E3-91E9-E7F1D2D1EE6E}"/>
          </ac:cxnSpMkLst>
        </pc:cxnChg>
        <pc:cxnChg chg="mod">
          <ac:chgData name="Héctor Cañeque Rufo" userId="6da3b7e2-2289-4c25-b14d-207ec07af19d" providerId="ADAL" clId="{110670A2-31F1-46D6-B9C0-FFC839AF2B13}" dt="2023-10-11T16:39:39.729" v="5489"/>
          <ac:cxnSpMkLst>
            <pc:docMk/>
            <pc:sldMk cId="3887338285" sldId="258"/>
            <ac:cxnSpMk id="50" creationId="{10968441-D10E-EA9F-F687-A95503CE478A}"/>
          </ac:cxnSpMkLst>
        </pc:cxnChg>
        <pc:cxnChg chg="mod">
          <ac:chgData name="Héctor Cañeque Rufo" userId="6da3b7e2-2289-4c25-b14d-207ec07af19d" providerId="ADAL" clId="{110670A2-31F1-46D6-B9C0-FFC839AF2B13}" dt="2023-10-11T16:39:39.729" v="5489"/>
          <ac:cxnSpMkLst>
            <pc:docMk/>
            <pc:sldMk cId="3887338285" sldId="258"/>
            <ac:cxnSpMk id="51" creationId="{3CF6D8AB-B088-F300-EE16-CD59EC7FBACA}"/>
          </ac:cxnSpMkLst>
        </pc:cxnChg>
        <pc:cxnChg chg="mod">
          <ac:chgData name="Héctor Cañeque Rufo" userId="6da3b7e2-2289-4c25-b14d-207ec07af19d" providerId="ADAL" clId="{110670A2-31F1-46D6-B9C0-FFC839AF2B13}" dt="2023-10-11T16:39:39.729" v="5489"/>
          <ac:cxnSpMkLst>
            <pc:docMk/>
            <pc:sldMk cId="3887338285" sldId="258"/>
            <ac:cxnSpMk id="52" creationId="{2798B890-F07A-435B-3059-C21306C83778}"/>
          </ac:cxnSpMkLst>
        </pc:cxnChg>
        <pc:cxnChg chg="mod">
          <ac:chgData name="Héctor Cañeque Rufo" userId="6da3b7e2-2289-4c25-b14d-207ec07af19d" providerId="ADAL" clId="{110670A2-31F1-46D6-B9C0-FFC839AF2B13}" dt="2023-10-11T16:39:39.729" v="5489"/>
          <ac:cxnSpMkLst>
            <pc:docMk/>
            <pc:sldMk cId="3887338285" sldId="258"/>
            <ac:cxnSpMk id="53" creationId="{30A19FD4-90A1-846D-D84C-50E10E5AB62B}"/>
          </ac:cxnSpMkLst>
        </pc:cxnChg>
        <pc:cxnChg chg="mod">
          <ac:chgData name="Héctor Cañeque Rufo" userId="6da3b7e2-2289-4c25-b14d-207ec07af19d" providerId="ADAL" clId="{110670A2-31F1-46D6-B9C0-FFC839AF2B13}" dt="2023-10-11T16:39:39.729" v="5489"/>
          <ac:cxnSpMkLst>
            <pc:docMk/>
            <pc:sldMk cId="3887338285" sldId="258"/>
            <ac:cxnSpMk id="54" creationId="{99C8C54D-B267-5618-791C-6E5AB774858C}"/>
          </ac:cxnSpMkLst>
        </pc:cxnChg>
        <pc:cxnChg chg="mod">
          <ac:chgData name="Héctor Cañeque Rufo" userId="6da3b7e2-2289-4c25-b14d-207ec07af19d" providerId="ADAL" clId="{110670A2-31F1-46D6-B9C0-FFC839AF2B13}" dt="2023-10-11T16:39:39.729" v="5489"/>
          <ac:cxnSpMkLst>
            <pc:docMk/>
            <pc:sldMk cId="3887338285" sldId="258"/>
            <ac:cxnSpMk id="55" creationId="{64D5EECC-62D6-10B2-2405-46D6CCA1F6E9}"/>
          </ac:cxnSpMkLst>
        </pc:cxnChg>
        <pc:cxnChg chg="mod">
          <ac:chgData name="Héctor Cañeque Rufo" userId="6da3b7e2-2289-4c25-b14d-207ec07af19d" providerId="ADAL" clId="{110670A2-31F1-46D6-B9C0-FFC839AF2B13}" dt="2023-10-11T16:39:39.729" v="5489"/>
          <ac:cxnSpMkLst>
            <pc:docMk/>
            <pc:sldMk cId="3887338285" sldId="258"/>
            <ac:cxnSpMk id="56" creationId="{8963011D-C5ED-79AD-B3B8-A83DE6B7D558}"/>
          </ac:cxnSpMkLst>
        </pc:cxnChg>
        <pc:cxnChg chg="mod">
          <ac:chgData name="Héctor Cañeque Rufo" userId="6da3b7e2-2289-4c25-b14d-207ec07af19d" providerId="ADAL" clId="{110670A2-31F1-46D6-B9C0-FFC839AF2B13}" dt="2023-10-11T16:39:39.729" v="5489"/>
          <ac:cxnSpMkLst>
            <pc:docMk/>
            <pc:sldMk cId="3887338285" sldId="258"/>
            <ac:cxnSpMk id="57" creationId="{33A6B3BE-275A-5D21-0456-207782C443F1}"/>
          </ac:cxnSpMkLst>
        </pc:cxnChg>
        <pc:cxnChg chg="mod">
          <ac:chgData name="Héctor Cañeque Rufo" userId="6da3b7e2-2289-4c25-b14d-207ec07af19d" providerId="ADAL" clId="{110670A2-31F1-46D6-B9C0-FFC839AF2B13}" dt="2023-10-11T16:39:39.729" v="5489"/>
          <ac:cxnSpMkLst>
            <pc:docMk/>
            <pc:sldMk cId="3887338285" sldId="258"/>
            <ac:cxnSpMk id="58" creationId="{E3C2237A-A2ED-A385-8073-987149BEB268}"/>
          </ac:cxnSpMkLst>
        </pc:cxnChg>
        <pc:cxnChg chg="mod">
          <ac:chgData name="Héctor Cañeque Rufo" userId="6da3b7e2-2289-4c25-b14d-207ec07af19d" providerId="ADAL" clId="{110670A2-31F1-46D6-B9C0-FFC839AF2B13}" dt="2023-10-11T16:39:39.729" v="5489"/>
          <ac:cxnSpMkLst>
            <pc:docMk/>
            <pc:sldMk cId="3887338285" sldId="258"/>
            <ac:cxnSpMk id="59" creationId="{F508ACFB-2D87-6AB9-7911-FEE840578047}"/>
          </ac:cxnSpMkLst>
        </pc:cxnChg>
      </pc:sldChg>
      <pc:sldChg chg="addSp delSp modSp add mod">
        <pc:chgData name="Héctor Cañeque Rufo" userId="6da3b7e2-2289-4c25-b14d-207ec07af19d" providerId="ADAL" clId="{110670A2-31F1-46D6-B9C0-FFC839AF2B13}" dt="2023-10-25T13:02:40.495" v="6496" actId="20577"/>
        <pc:sldMkLst>
          <pc:docMk/>
          <pc:sldMk cId="2991595023" sldId="259"/>
        </pc:sldMkLst>
        <pc:spChg chg="add mod">
          <ac:chgData name="Héctor Cañeque Rufo" userId="6da3b7e2-2289-4c25-b14d-207ec07af19d" providerId="ADAL" clId="{110670A2-31F1-46D6-B9C0-FFC839AF2B13}" dt="2023-10-25T13:02:40.495" v="6496" actId="20577"/>
          <ac:spMkLst>
            <pc:docMk/>
            <pc:sldMk cId="2991595023" sldId="259"/>
            <ac:spMk id="6" creationId="{0A33E0DE-7BB7-BD31-E1AC-634594C94CCF}"/>
          </ac:spMkLst>
        </pc:spChg>
        <pc:spChg chg="del">
          <ac:chgData name="Héctor Cañeque Rufo" userId="6da3b7e2-2289-4c25-b14d-207ec07af19d" providerId="ADAL" clId="{110670A2-31F1-46D6-B9C0-FFC839AF2B13}" dt="2023-10-11T16:40:03.885" v="5495" actId="478"/>
          <ac:spMkLst>
            <pc:docMk/>
            <pc:sldMk cId="2991595023" sldId="259"/>
            <ac:spMk id="21" creationId="{54826E5E-9298-8F37-8F51-631DB6F6993B}"/>
          </ac:spMkLst>
        </pc:spChg>
        <pc:spChg chg="del">
          <ac:chgData name="Héctor Cañeque Rufo" userId="6da3b7e2-2289-4c25-b14d-207ec07af19d" providerId="ADAL" clId="{110670A2-31F1-46D6-B9C0-FFC839AF2B13}" dt="2023-10-11T16:40:08.352" v="5497" actId="478"/>
          <ac:spMkLst>
            <pc:docMk/>
            <pc:sldMk cId="2991595023" sldId="259"/>
            <ac:spMk id="22" creationId="{6A807A99-5770-26EF-83F9-A6A8D108BAE3}"/>
          </ac:spMkLst>
        </pc:spChg>
        <pc:spChg chg="del">
          <ac:chgData name="Héctor Cañeque Rufo" userId="6da3b7e2-2289-4c25-b14d-207ec07af19d" providerId="ADAL" clId="{110670A2-31F1-46D6-B9C0-FFC839AF2B13}" dt="2023-10-11T16:39:58.232" v="5494" actId="478"/>
          <ac:spMkLst>
            <pc:docMk/>
            <pc:sldMk cId="2991595023" sldId="259"/>
            <ac:spMk id="23" creationId="{61A91876-C028-5567-9581-C18C4AAD189F}"/>
          </ac:spMkLst>
        </pc:spChg>
        <pc:grpChg chg="del mod">
          <ac:chgData name="Héctor Cañeque Rufo" userId="6da3b7e2-2289-4c25-b14d-207ec07af19d" providerId="ADAL" clId="{110670A2-31F1-46D6-B9C0-FFC839AF2B13}" dt="2023-10-13T07:17:50.189" v="6268" actId="478"/>
          <ac:grpSpMkLst>
            <pc:docMk/>
            <pc:sldMk cId="2991595023" sldId="259"/>
            <ac:grpSpMk id="2" creationId="{79DC0F99-6F31-3097-AA3A-4E6829BE8A7C}"/>
          </ac:grpSpMkLst>
        </pc:grpChg>
        <pc:picChg chg="del">
          <ac:chgData name="Héctor Cañeque Rufo" userId="6da3b7e2-2289-4c25-b14d-207ec07af19d" providerId="ADAL" clId="{110670A2-31F1-46D6-B9C0-FFC839AF2B13}" dt="2023-10-11T16:40:03.885" v="5495" actId="478"/>
          <ac:picMkLst>
            <pc:docMk/>
            <pc:sldMk cId="2991595023" sldId="259"/>
            <ac:picMk id="6" creationId="{C47E6BA4-4479-B515-6C61-9218E35EA25F}"/>
          </ac:picMkLst>
        </pc:picChg>
        <pc:picChg chg="del">
          <ac:chgData name="Héctor Cañeque Rufo" userId="6da3b7e2-2289-4c25-b14d-207ec07af19d" providerId="ADAL" clId="{110670A2-31F1-46D6-B9C0-FFC839AF2B13}" dt="2023-10-11T16:39:51.788" v="5491" actId="478"/>
          <ac:picMkLst>
            <pc:docMk/>
            <pc:sldMk cId="2991595023" sldId="259"/>
            <ac:picMk id="7" creationId="{265DDCD2-73FD-FCC3-6978-A9DF6E8F5A43}"/>
          </ac:picMkLst>
        </pc:picChg>
        <pc:picChg chg="del">
          <ac:chgData name="Héctor Cañeque Rufo" userId="6da3b7e2-2289-4c25-b14d-207ec07af19d" providerId="ADAL" clId="{110670A2-31F1-46D6-B9C0-FFC839AF2B13}" dt="2023-10-11T16:40:03.885" v="5495" actId="478"/>
          <ac:picMkLst>
            <pc:docMk/>
            <pc:sldMk cId="2991595023" sldId="259"/>
            <ac:picMk id="12" creationId="{9C80E917-8625-BD51-DB49-917151A4F2D2}"/>
          </ac:picMkLst>
        </pc:picChg>
        <pc:picChg chg="del">
          <ac:chgData name="Héctor Cañeque Rufo" userId="6da3b7e2-2289-4c25-b14d-207ec07af19d" providerId="ADAL" clId="{110670A2-31F1-46D6-B9C0-FFC839AF2B13}" dt="2023-10-11T16:40:03.885" v="5495" actId="478"/>
          <ac:picMkLst>
            <pc:docMk/>
            <pc:sldMk cId="2991595023" sldId="259"/>
            <ac:picMk id="13" creationId="{7A3A51E2-91FA-7E94-C135-E09B6717C731}"/>
          </ac:picMkLst>
        </pc:picChg>
        <pc:picChg chg="del">
          <ac:chgData name="Héctor Cañeque Rufo" userId="6da3b7e2-2289-4c25-b14d-207ec07af19d" providerId="ADAL" clId="{110670A2-31F1-46D6-B9C0-FFC839AF2B13}" dt="2023-10-11T16:40:03.885" v="5495" actId="478"/>
          <ac:picMkLst>
            <pc:docMk/>
            <pc:sldMk cId="2991595023" sldId="259"/>
            <ac:picMk id="18" creationId="{DA55C7F4-6D6B-A553-D147-77A365D4BCF8}"/>
          </ac:picMkLst>
        </pc:picChg>
        <pc:picChg chg="del">
          <ac:chgData name="Héctor Cañeque Rufo" userId="6da3b7e2-2289-4c25-b14d-207ec07af19d" providerId="ADAL" clId="{110670A2-31F1-46D6-B9C0-FFC839AF2B13}" dt="2023-10-11T16:40:05.724" v="5496" actId="478"/>
          <ac:picMkLst>
            <pc:docMk/>
            <pc:sldMk cId="2991595023" sldId="259"/>
            <ac:picMk id="19" creationId="{9724040B-0196-9AD6-E635-0094BB96A211}"/>
          </ac:picMkLst>
        </pc:picChg>
        <pc:picChg chg="del">
          <ac:chgData name="Héctor Cañeque Rufo" userId="6da3b7e2-2289-4c25-b14d-207ec07af19d" providerId="ADAL" clId="{110670A2-31F1-46D6-B9C0-FFC839AF2B13}" dt="2023-10-11T16:39:56.171" v="5493" actId="478"/>
          <ac:picMkLst>
            <pc:docMk/>
            <pc:sldMk cId="2991595023" sldId="259"/>
            <ac:picMk id="24" creationId="{14033417-772B-A47C-5E24-843A3841337A}"/>
          </ac:picMkLst>
        </pc:picChg>
        <pc:picChg chg="del">
          <ac:chgData name="Héctor Cañeque Rufo" userId="6da3b7e2-2289-4c25-b14d-207ec07af19d" providerId="ADAL" clId="{110670A2-31F1-46D6-B9C0-FFC839AF2B13}" dt="2023-10-11T16:39:53.619" v="5492" actId="478"/>
          <ac:picMkLst>
            <pc:docMk/>
            <pc:sldMk cId="2991595023" sldId="259"/>
            <ac:picMk id="26" creationId="{F01FA171-A34E-7474-ED42-645951E30860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9C684-5A97-46FA-8FD3-33143915B12B}" type="datetimeFigureOut">
              <a:rPr lang="es-ES" smtClean="0"/>
              <a:t>06/03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1FB50-CA01-450A-9988-A787F6B636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685537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9C684-5A97-46FA-8FD3-33143915B12B}" type="datetimeFigureOut">
              <a:rPr lang="es-ES" smtClean="0"/>
              <a:t>06/03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1FB50-CA01-450A-9988-A787F6B636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026324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9C684-5A97-46FA-8FD3-33143915B12B}" type="datetimeFigureOut">
              <a:rPr lang="es-ES" smtClean="0"/>
              <a:t>06/03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1FB50-CA01-450A-9988-A787F6B636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493676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9C684-5A97-46FA-8FD3-33143915B12B}" type="datetimeFigureOut">
              <a:rPr lang="es-ES" smtClean="0"/>
              <a:t>06/03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1FB50-CA01-450A-9988-A787F6B636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08976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9C684-5A97-46FA-8FD3-33143915B12B}" type="datetimeFigureOut">
              <a:rPr lang="es-ES" smtClean="0"/>
              <a:t>06/03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1FB50-CA01-450A-9988-A787F6B636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683263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9C684-5A97-46FA-8FD3-33143915B12B}" type="datetimeFigureOut">
              <a:rPr lang="es-ES" smtClean="0"/>
              <a:t>06/03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1FB50-CA01-450A-9988-A787F6B636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21598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9C684-5A97-46FA-8FD3-33143915B12B}" type="datetimeFigureOut">
              <a:rPr lang="es-ES" smtClean="0"/>
              <a:t>06/03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1FB50-CA01-450A-9988-A787F6B636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16093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9C684-5A97-46FA-8FD3-33143915B12B}" type="datetimeFigureOut">
              <a:rPr lang="es-ES" smtClean="0"/>
              <a:t>06/03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1FB50-CA01-450A-9988-A787F6B636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232756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9C684-5A97-46FA-8FD3-33143915B12B}" type="datetimeFigureOut">
              <a:rPr lang="es-ES" smtClean="0"/>
              <a:t>06/03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1FB50-CA01-450A-9988-A787F6B636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95969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9C684-5A97-46FA-8FD3-33143915B12B}" type="datetimeFigureOut">
              <a:rPr lang="es-ES" smtClean="0"/>
              <a:t>06/03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1FB50-CA01-450A-9988-A787F6B636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011412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9C684-5A97-46FA-8FD3-33143915B12B}" type="datetimeFigureOut">
              <a:rPr lang="es-ES" smtClean="0"/>
              <a:t>06/03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1FB50-CA01-450A-9988-A787F6B636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5569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E9C684-5A97-46FA-8FD3-33143915B12B}" type="datetimeFigureOut">
              <a:rPr lang="es-ES" smtClean="0"/>
              <a:t>06/03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D1FB50-CA01-450A-9988-A787F6B636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633847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>
            <a:extLst>
              <a:ext uri="{FF2B5EF4-FFF2-40B4-BE49-F238E27FC236}">
                <a16:creationId xmlns:a16="http://schemas.microsoft.com/office/drawing/2014/main" id="{7E5BB1FB-FA84-D524-2CCD-F8D04427321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5062" y="1550106"/>
            <a:ext cx="4526092" cy="1066074"/>
          </a:xfrm>
          <a:prstGeom prst="rect">
            <a:avLst/>
          </a:prstGeom>
        </p:spPr>
      </p:pic>
      <p:sp>
        <p:nvSpPr>
          <p:cNvPr id="6" name="Cuadro de texto 47">
            <a:extLst>
              <a:ext uri="{FF2B5EF4-FFF2-40B4-BE49-F238E27FC236}">
                <a16:creationId xmlns:a16="http://schemas.microsoft.com/office/drawing/2014/main" id="{CCCB4646-A728-A888-3305-97837D3E0B2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9000" y="2915525"/>
            <a:ext cx="6480000" cy="851803"/>
          </a:xfrm>
          <a:prstGeom prst="rect">
            <a:avLst/>
          </a:prstGeom>
          <a:noFill/>
          <a:ln>
            <a:noFill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GB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1. </a:t>
            </a: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epresentative experimental designs scheme</a:t>
            </a:r>
            <a:r>
              <a:rPr lang="en-GB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xperimental design (A). 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epresentative scheme of the n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vel object recognition (NOR) test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(B).</a:t>
            </a:r>
            <a:endParaRPr lang="en-GB" sz="1200" dirty="0">
              <a:ea typeface="Times New Roman" panose="02020603050405020304" pitchFamily="18" charset="0"/>
            </a:endParaRPr>
          </a:p>
        </p:txBody>
      </p:sp>
      <p:grpSp>
        <p:nvGrpSpPr>
          <p:cNvPr id="14" name="Grupo 13">
            <a:extLst>
              <a:ext uri="{FF2B5EF4-FFF2-40B4-BE49-F238E27FC236}">
                <a16:creationId xmlns:a16="http://schemas.microsoft.com/office/drawing/2014/main" id="{1ED116A4-B5F2-291A-AB3F-2825CD35CC13}"/>
              </a:ext>
            </a:extLst>
          </p:cNvPr>
          <p:cNvGrpSpPr/>
          <p:nvPr/>
        </p:nvGrpSpPr>
        <p:grpSpPr>
          <a:xfrm>
            <a:off x="112460" y="145339"/>
            <a:ext cx="3965205" cy="1484007"/>
            <a:chOff x="112460" y="3863899"/>
            <a:chExt cx="3965205" cy="1484007"/>
          </a:xfrm>
        </p:grpSpPr>
        <p:pic>
          <p:nvPicPr>
            <p:cNvPr id="7" name="Imagen 6">
              <a:extLst>
                <a:ext uri="{FF2B5EF4-FFF2-40B4-BE49-F238E27FC236}">
                  <a16:creationId xmlns:a16="http://schemas.microsoft.com/office/drawing/2014/main" id="{3701548B-1FAF-0049-1EF4-8CD2F44AFE3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07734" y="3998976"/>
              <a:ext cx="3669931" cy="1071931"/>
            </a:xfrm>
            <a:prstGeom prst="rect">
              <a:avLst/>
            </a:prstGeom>
          </p:spPr>
        </p:pic>
        <p:sp>
          <p:nvSpPr>
            <p:cNvPr id="5" name="CuadroTexto 4">
              <a:extLst>
                <a:ext uri="{FF2B5EF4-FFF2-40B4-BE49-F238E27FC236}">
                  <a16:creationId xmlns:a16="http://schemas.microsoft.com/office/drawing/2014/main" id="{4062DF7B-554A-80FF-4FF2-3BF3DA7BF365}"/>
                </a:ext>
              </a:extLst>
            </p:cNvPr>
            <p:cNvSpPr txBox="1"/>
            <p:nvPr/>
          </p:nvSpPr>
          <p:spPr>
            <a:xfrm>
              <a:off x="112460" y="5070907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3" name="CuadroTexto 12">
              <a:extLst>
                <a:ext uri="{FF2B5EF4-FFF2-40B4-BE49-F238E27FC236}">
                  <a16:creationId xmlns:a16="http://schemas.microsoft.com/office/drawing/2014/main" id="{EB178931-0247-A925-41C2-F61EAB08EED4}"/>
                </a:ext>
              </a:extLst>
            </p:cNvPr>
            <p:cNvSpPr txBox="1"/>
            <p:nvPr/>
          </p:nvSpPr>
          <p:spPr>
            <a:xfrm>
              <a:off x="112460" y="3863899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07760071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16</TotalTime>
  <Words>30</Words>
  <Application>Microsoft Office PowerPoint</Application>
  <PresentationFormat>A4 (210 x 297 mm)</PresentationFormat>
  <Paragraphs>3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Héctor Cañeque Rufo</dc:creator>
  <cp:lastModifiedBy>Héctor Cañeque Rufo</cp:lastModifiedBy>
  <cp:revision>1</cp:revision>
  <dcterms:created xsi:type="dcterms:W3CDTF">2023-10-11T15:18:34Z</dcterms:created>
  <dcterms:modified xsi:type="dcterms:W3CDTF">2024-03-06T11:18:17Z</dcterms:modified>
</cp:coreProperties>
</file>